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620000" cy="3048000"/>
  <p:notesSz cx="6858000" cy="9144000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C38D70B-178A-E288-156F-6A9FB0397618}" name="Ellen Mercado, PhD, CMPP (HI)" initials="EMPC(" userId="S::Ellen.Mercado@healthinteractions.com::514dbd47-c532-47b4-9cf3-82d51d4dd156" providerId="AD"/>
  <p188:author id="{331B5B45-FBF4-0588-C612-B2DAD4755AAA}" name="Carolyn Maskin, PhD (HI)" initials="CMP(" userId="S::Carolyn.Maskin@healthinteractions.com::d6ecf799-e21f-4bf4-bc33-c77904cc295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B5E0"/>
    <a:srgbClr val="66AFA5"/>
    <a:srgbClr val="2C5290"/>
    <a:srgbClr val="F2F8F7"/>
    <a:srgbClr val="FFFFFF"/>
    <a:srgbClr val="F0EDF3"/>
    <a:srgbClr val="B40000"/>
    <a:srgbClr val="BA9B2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120" y="2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52500" y="498828"/>
            <a:ext cx="5715000" cy="1061156"/>
          </a:xfrm>
        </p:spPr>
        <p:txBody>
          <a:bodyPr anchor="b"/>
          <a:lstStyle>
            <a:lvl1pPr algn="ctr">
              <a:defRPr sz="2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52500" y="1600906"/>
            <a:ext cx="5715000" cy="735894"/>
          </a:xfrm>
        </p:spPr>
        <p:txBody>
          <a:bodyPr/>
          <a:lstStyle>
            <a:lvl1pPr marL="0" indent="0" algn="ctr">
              <a:buNone/>
              <a:defRPr sz="1067"/>
            </a:lvl1pPr>
            <a:lvl2pPr marL="203180" indent="0" algn="ctr">
              <a:buNone/>
              <a:defRPr sz="889"/>
            </a:lvl2pPr>
            <a:lvl3pPr marL="406359" indent="0" algn="ctr">
              <a:buNone/>
              <a:defRPr sz="800"/>
            </a:lvl3pPr>
            <a:lvl4pPr marL="609539" indent="0" algn="ctr">
              <a:buNone/>
              <a:defRPr sz="711"/>
            </a:lvl4pPr>
            <a:lvl5pPr marL="812719" indent="0" algn="ctr">
              <a:buNone/>
              <a:defRPr sz="711"/>
            </a:lvl5pPr>
            <a:lvl6pPr marL="1015898" indent="0" algn="ctr">
              <a:buNone/>
              <a:defRPr sz="711"/>
            </a:lvl6pPr>
            <a:lvl7pPr marL="1219078" indent="0" algn="ctr">
              <a:buNone/>
              <a:defRPr sz="711"/>
            </a:lvl7pPr>
            <a:lvl8pPr marL="1422258" indent="0" algn="ctr">
              <a:buNone/>
              <a:defRPr sz="711"/>
            </a:lvl8pPr>
            <a:lvl9pPr marL="1625437" indent="0" algn="ctr">
              <a:buNone/>
              <a:defRPr sz="71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45198733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960" userDrawn="1">
          <p15:clr>
            <a:srgbClr val="FBAE40"/>
          </p15:clr>
        </p15:guide>
        <p15:guide id="2" pos="240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19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53062" y="162278"/>
            <a:ext cx="1643063" cy="25830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3875" y="162278"/>
            <a:ext cx="4833938" cy="25830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8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698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906" y="759884"/>
            <a:ext cx="6572250" cy="1267883"/>
          </a:xfrm>
        </p:spPr>
        <p:txBody>
          <a:bodyPr anchor="b"/>
          <a:lstStyle>
            <a:lvl1pPr>
              <a:defRPr sz="2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906" y="2039761"/>
            <a:ext cx="6572250" cy="666750"/>
          </a:xfrm>
        </p:spPr>
        <p:txBody>
          <a:bodyPr/>
          <a:lstStyle>
            <a:lvl1pPr marL="0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1pPr>
            <a:lvl2pPr marL="203180" indent="0">
              <a:buNone/>
              <a:defRPr sz="889">
                <a:solidFill>
                  <a:schemeClr val="tx1">
                    <a:tint val="75000"/>
                  </a:schemeClr>
                </a:solidFill>
              </a:defRPr>
            </a:lvl2pPr>
            <a:lvl3pPr marL="406359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3pPr>
            <a:lvl4pPr marL="609539" indent="0">
              <a:buNone/>
              <a:defRPr sz="711">
                <a:solidFill>
                  <a:schemeClr val="tx1">
                    <a:tint val="75000"/>
                  </a:schemeClr>
                </a:solidFill>
              </a:defRPr>
            </a:lvl4pPr>
            <a:lvl5pPr marL="812719" indent="0">
              <a:buNone/>
              <a:defRPr sz="711">
                <a:solidFill>
                  <a:schemeClr val="tx1">
                    <a:tint val="75000"/>
                  </a:schemeClr>
                </a:solidFill>
              </a:defRPr>
            </a:lvl5pPr>
            <a:lvl6pPr marL="1015898" indent="0">
              <a:buNone/>
              <a:defRPr sz="711">
                <a:solidFill>
                  <a:schemeClr val="tx1">
                    <a:tint val="75000"/>
                  </a:schemeClr>
                </a:solidFill>
              </a:defRPr>
            </a:lvl6pPr>
            <a:lvl7pPr marL="1219078" indent="0">
              <a:buNone/>
              <a:defRPr sz="711">
                <a:solidFill>
                  <a:schemeClr val="tx1">
                    <a:tint val="75000"/>
                  </a:schemeClr>
                </a:solidFill>
              </a:defRPr>
            </a:lvl7pPr>
            <a:lvl8pPr marL="1422258" indent="0">
              <a:buNone/>
              <a:defRPr sz="711">
                <a:solidFill>
                  <a:schemeClr val="tx1">
                    <a:tint val="75000"/>
                  </a:schemeClr>
                </a:solidFill>
              </a:defRPr>
            </a:lvl8pPr>
            <a:lvl9pPr marL="1625437" indent="0">
              <a:buNone/>
              <a:defRPr sz="7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608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3875" y="811389"/>
            <a:ext cx="3238500" cy="19339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57625" y="811389"/>
            <a:ext cx="3238500" cy="19339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887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4867" y="162278"/>
            <a:ext cx="6572250" cy="58913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4868" y="747184"/>
            <a:ext cx="3223617" cy="366183"/>
          </a:xfrm>
        </p:spPr>
        <p:txBody>
          <a:bodyPr anchor="b"/>
          <a:lstStyle>
            <a:lvl1pPr marL="0" indent="0">
              <a:buNone/>
              <a:defRPr sz="1067" b="1"/>
            </a:lvl1pPr>
            <a:lvl2pPr marL="203180" indent="0">
              <a:buNone/>
              <a:defRPr sz="889" b="1"/>
            </a:lvl2pPr>
            <a:lvl3pPr marL="406359" indent="0">
              <a:buNone/>
              <a:defRPr sz="800" b="1"/>
            </a:lvl3pPr>
            <a:lvl4pPr marL="609539" indent="0">
              <a:buNone/>
              <a:defRPr sz="711" b="1"/>
            </a:lvl4pPr>
            <a:lvl5pPr marL="812719" indent="0">
              <a:buNone/>
              <a:defRPr sz="711" b="1"/>
            </a:lvl5pPr>
            <a:lvl6pPr marL="1015898" indent="0">
              <a:buNone/>
              <a:defRPr sz="711" b="1"/>
            </a:lvl6pPr>
            <a:lvl7pPr marL="1219078" indent="0">
              <a:buNone/>
              <a:defRPr sz="711" b="1"/>
            </a:lvl7pPr>
            <a:lvl8pPr marL="1422258" indent="0">
              <a:buNone/>
              <a:defRPr sz="711" b="1"/>
            </a:lvl8pPr>
            <a:lvl9pPr marL="1625437" indent="0">
              <a:buNone/>
              <a:defRPr sz="7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4868" y="1113367"/>
            <a:ext cx="3223617" cy="16375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57625" y="747184"/>
            <a:ext cx="3239493" cy="366183"/>
          </a:xfrm>
        </p:spPr>
        <p:txBody>
          <a:bodyPr anchor="b"/>
          <a:lstStyle>
            <a:lvl1pPr marL="0" indent="0">
              <a:buNone/>
              <a:defRPr sz="1067" b="1"/>
            </a:lvl1pPr>
            <a:lvl2pPr marL="203180" indent="0">
              <a:buNone/>
              <a:defRPr sz="889" b="1"/>
            </a:lvl2pPr>
            <a:lvl3pPr marL="406359" indent="0">
              <a:buNone/>
              <a:defRPr sz="800" b="1"/>
            </a:lvl3pPr>
            <a:lvl4pPr marL="609539" indent="0">
              <a:buNone/>
              <a:defRPr sz="711" b="1"/>
            </a:lvl4pPr>
            <a:lvl5pPr marL="812719" indent="0">
              <a:buNone/>
              <a:defRPr sz="711" b="1"/>
            </a:lvl5pPr>
            <a:lvl6pPr marL="1015898" indent="0">
              <a:buNone/>
              <a:defRPr sz="711" b="1"/>
            </a:lvl6pPr>
            <a:lvl7pPr marL="1219078" indent="0">
              <a:buNone/>
              <a:defRPr sz="711" b="1"/>
            </a:lvl7pPr>
            <a:lvl8pPr marL="1422258" indent="0">
              <a:buNone/>
              <a:defRPr sz="711" b="1"/>
            </a:lvl8pPr>
            <a:lvl9pPr marL="1625437" indent="0">
              <a:buNone/>
              <a:defRPr sz="7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57625" y="1113367"/>
            <a:ext cx="3239493" cy="16375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00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359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649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4868" y="203200"/>
            <a:ext cx="2457648" cy="711200"/>
          </a:xfrm>
        </p:spPr>
        <p:txBody>
          <a:bodyPr anchor="b"/>
          <a:lstStyle>
            <a:lvl1pPr>
              <a:defRPr sz="14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39493" y="438856"/>
            <a:ext cx="3857625" cy="2166056"/>
          </a:xfrm>
        </p:spPr>
        <p:txBody>
          <a:bodyPr/>
          <a:lstStyle>
            <a:lvl1pPr>
              <a:defRPr sz="1422"/>
            </a:lvl1pPr>
            <a:lvl2pPr>
              <a:defRPr sz="1244"/>
            </a:lvl2pPr>
            <a:lvl3pPr>
              <a:defRPr sz="1067"/>
            </a:lvl3pPr>
            <a:lvl4pPr>
              <a:defRPr sz="889"/>
            </a:lvl4pPr>
            <a:lvl5pPr>
              <a:defRPr sz="889"/>
            </a:lvl5pPr>
            <a:lvl6pPr>
              <a:defRPr sz="889"/>
            </a:lvl6pPr>
            <a:lvl7pPr>
              <a:defRPr sz="889"/>
            </a:lvl7pPr>
            <a:lvl8pPr>
              <a:defRPr sz="889"/>
            </a:lvl8pPr>
            <a:lvl9pPr>
              <a:defRPr sz="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4868" y="914400"/>
            <a:ext cx="2457648" cy="1694039"/>
          </a:xfrm>
        </p:spPr>
        <p:txBody>
          <a:bodyPr/>
          <a:lstStyle>
            <a:lvl1pPr marL="0" indent="0">
              <a:buNone/>
              <a:defRPr sz="711"/>
            </a:lvl1pPr>
            <a:lvl2pPr marL="203180" indent="0">
              <a:buNone/>
              <a:defRPr sz="622"/>
            </a:lvl2pPr>
            <a:lvl3pPr marL="406359" indent="0">
              <a:buNone/>
              <a:defRPr sz="533"/>
            </a:lvl3pPr>
            <a:lvl4pPr marL="609539" indent="0">
              <a:buNone/>
              <a:defRPr sz="444"/>
            </a:lvl4pPr>
            <a:lvl5pPr marL="812719" indent="0">
              <a:buNone/>
              <a:defRPr sz="444"/>
            </a:lvl5pPr>
            <a:lvl6pPr marL="1015898" indent="0">
              <a:buNone/>
              <a:defRPr sz="444"/>
            </a:lvl6pPr>
            <a:lvl7pPr marL="1219078" indent="0">
              <a:buNone/>
              <a:defRPr sz="444"/>
            </a:lvl7pPr>
            <a:lvl8pPr marL="1422258" indent="0">
              <a:buNone/>
              <a:defRPr sz="444"/>
            </a:lvl8pPr>
            <a:lvl9pPr marL="1625437" indent="0">
              <a:buNone/>
              <a:defRPr sz="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601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4868" y="203200"/>
            <a:ext cx="2457648" cy="711200"/>
          </a:xfrm>
        </p:spPr>
        <p:txBody>
          <a:bodyPr anchor="b"/>
          <a:lstStyle>
            <a:lvl1pPr>
              <a:defRPr sz="14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39493" y="438856"/>
            <a:ext cx="3857625" cy="2166056"/>
          </a:xfrm>
        </p:spPr>
        <p:txBody>
          <a:bodyPr anchor="t"/>
          <a:lstStyle>
            <a:lvl1pPr marL="0" indent="0">
              <a:buNone/>
              <a:defRPr sz="1422"/>
            </a:lvl1pPr>
            <a:lvl2pPr marL="203180" indent="0">
              <a:buNone/>
              <a:defRPr sz="1244"/>
            </a:lvl2pPr>
            <a:lvl3pPr marL="406359" indent="0">
              <a:buNone/>
              <a:defRPr sz="1067"/>
            </a:lvl3pPr>
            <a:lvl4pPr marL="609539" indent="0">
              <a:buNone/>
              <a:defRPr sz="889"/>
            </a:lvl4pPr>
            <a:lvl5pPr marL="812719" indent="0">
              <a:buNone/>
              <a:defRPr sz="889"/>
            </a:lvl5pPr>
            <a:lvl6pPr marL="1015898" indent="0">
              <a:buNone/>
              <a:defRPr sz="889"/>
            </a:lvl6pPr>
            <a:lvl7pPr marL="1219078" indent="0">
              <a:buNone/>
              <a:defRPr sz="889"/>
            </a:lvl7pPr>
            <a:lvl8pPr marL="1422258" indent="0">
              <a:buNone/>
              <a:defRPr sz="889"/>
            </a:lvl8pPr>
            <a:lvl9pPr marL="1625437" indent="0">
              <a:buNone/>
              <a:defRPr sz="88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4868" y="914400"/>
            <a:ext cx="2457648" cy="1694039"/>
          </a:xfrm>
        </p:spPr>
        <p:txBody>
          <a:bodyPr/>
          <a:lstStyle>
            <a:lvl1pPr marL="0" indent="0">
              <a:buNone/>
              <a:defRPr sz="711"/>
            </a:lvl1pPr>
            <a:lvl2pPr marL="203180" indent="0">
              <a:buNone/>
              <a:defRPr sz="622"/>
            </a:lvl2pPr>
            <a:lvl3pPr marL="406359" indent="0">
              <a:buNone/>
              <a:defRPr sz="533"/>
            </a:lvl3pPr>
            <a:lvl4pPr marL="609539" indent="0">
              <a:buNone/>
              <a:defRPr sz="444"/>
            </a:lvl4pPr>
            <a:lvl5pPr marL="812719" indent="0">
              <a:buNone/>
              <a:defRPr sz="444"/>
            </a:lvl5pPr>
            <a:lvl6pPr marL="1015898" indent="0">
              <a:buNone/>
              <a:defRPr sz="444"/>
            </a:lvl6pPr>
            <a:lvl7pPr marL="1219078" indent="0">
              <a:buNone/>
              <a:defRPr sz="444"/>
            </a:lvl7pPr>
            <a:lvl8pPr marL="1422258" indent="0">
              <a:buNone/>
              <a:defRPr sz="444"/>
            </a:lvl8pPr>
            <a:lvl9pPr marL="1625437" indent="0">
              <a:buNone/>
              <a:defRPr sz="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923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3875" y="162278"/>
            <a:ext cx="6572250" cy="58913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3875" y="811389"/>
            <a:ext cx="6572250" cy="19339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3875" y="2825045"/>
            <a:ext cx="1714500" cy="1622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1AA2F-0D2D-443E-8AA4-A01CFD128F5F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24125" y="2825045"/>
            <a:ext cx="2571750" cy="1622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81625" y="2825045"/>
            <a:ext cx="1714500" cy="1622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93921-B633-4447-A58C-430CDDF1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384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06359" rtl="0" eaLnBrk="1" latinLnBrk="0" hangingPunct="1">
        <a:lnSpc>
          <a:spcPct val="90000"/>
        </a:lnSpc>
        <a:spcBef>
          <a:spcPct val="0"/>
        </a:spcBef>
        <a:buNone/>
        <a:defRPr sz="19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1590" indent="-101590" algn="l" defTabSz="406359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244" kern="1200">
          <a:solidFill>
            <a:schemeClr val="tx1"/>
          </a:solidFill>
          <a:latin typeface="+mn-lt"/>
          <a:ea typeface="+mn-ea"/>
          <a:cs typeface="+mn-cs"/>
        </a:defRPr>
      </a:lvl1pPr>
      <a:lvl2pPr marL="304770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1067" kern="1200">
          <a:solidFill>
            <a:schemeClr val="tx1"/>
          </a:solidFill>
          <a:latin typeface="+mn-lt"/>
          <a:ea typeface="+mn-ea"/>
          <a:cs typeface="+mn-cs"/>
        </a:defRPr>
      </a:lvl2pPr>
      <a:lvl3pPr marL="507949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89" kern="1200">
          <a:solidFill>
            <a:schemeClr val="tx1"/>
          </a:solidFill>
          <a:latin typeface="+mn-lt"/>
          <a:ea typeface="+mn-ea"/>
          <a:cs typeface="+mn-cs"/>
        </a:defRPr>
      </a:lvl3pPr>
      <a:lvl4pPr marL="711129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4pPr>
      <a:lvl5pPr marL="914309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5pPr>
      <a:lvl6pPr marL="1117488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6pPr>
      <a:lvl7pPr marL="1320668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7pPr>
      <a:lvl8pPr marL="1523848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8pPr>
      <a:lvl9pPr marL="1727027" indent="-101590" algn="l" defTabSz="406359" rtl="0" eaLnBrk="1" latinLnBrk="0" hangingPunct="1">
        <a:lnSpc>
          <a:spcPct val="90000"/>
        </a:lnSpc>
        <a:spcBef>
          <a:spcPts val="222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1pPr>
      <a:lvl2pPr marL="203180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2pPr>
      <a:lvl3pPr marL="406359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3pPr>
      <a:lvl4pPr marL="609539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4pPr>
      <a:lvl5pPr marL="812719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5pPr>
      <a:lvl6pPr marL="1015898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6pPr>
      <a:lvl7pPr marL="1219078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7pPr>
      <a:lvl8pPr marL="1422258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8pPr>
      <a:lvl9pPr marL="1625437" algn="l" defTabSz="406359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3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Rectangle: Rounded Corners 221">
            <a:extLst>
              <a:ext uri="{FF2B5EF4-FFF2-40B4-BE49-F238E27FC236}">
                <a16:creationId xmlns:a16="http://schemas.microsoft.com/office/drawing/2014/main" id="{D3E0CD4C-3D2B-A612-533E-819C40B0A581}"/>
              </a:ext>
            </a:extLst>
          </p:cNvPr>
          <p:cNvSpPr/>
          <p:nvPr/>
        </p:nvSpPr>
        <p:spPr>
          <a:xfrm>
            <a:off x="1998916" y="1845662"/>
            <a:ext cx="1554480" cy="1200748"/>
          </a:xfrm>
          <a:prstGeom prst="roundRect">
            <a:avLst>
              <a:gd name="adj" fmla="val 8755"/>
            </a:avLst>
          </a:prstGeom>
          <a:gradFill>
            <a:gsLst>
              <a:gs pos="100000">
                <a:srgbClr val="F0EDF3">
                  <a:alpha val="0"/>
                </a:srgbClr>
              </a:gs>
              <a:gs pos="0">
                <a:srgbClr val="FFFFFF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Rectangle: Rounded Corners 222">
            <a:extLst>
              <a:ext uri="{FF2B5EF4-FFF2-40B4-BE49-F238E27FC236}">
                <a16:creationId xmlns:a16="http://schemas.microsoft.com/office/drawing/2014/main" id="{24C8A5B7-F341-9E82-9B57-D3340B2596A0}"/>
              </a:ext>
            </a:extLst>
          </p:cNvPr>
          <p:cNvSpPr/>
          <p:nvPr/>
        </p:nvSpPr>
        <p:spPr>
          <a:xfrm>
            <a:off x="4068720" y="1852257"/>
            <a:ext cx="1554480" cy="1202434"/>
          </a:xfrm>
          <a:prstGeom prst="roundRect">
            <a:avLst>
              <a:gd name="adj" fmla="val 10792"/>
            </a:avLst>
          </a:prstGeom>
          <a:gradFill>
            <a:gsLst>
              <a:gs pos="100000">
                <a:srgbClr val="F0EDF3">
                  <a:alpha val="0"/>
                </a:srgbClr>
              </a:gs>
              <a:gs pos="0">
                <a:srgbClr val="FFFFFF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224" name="Rectangle: Rounded Corners 223">
            <a:extLst>
              <a:ext uri="{FF2B5EF4-FFF2-40B4-BE49-F238E27FC236}">
                <a16:creationId xmlns:a16="http://schemas.microsoft.com/office/drawing/2014/main" id="{2051AC00-2F3A-7BA1-B1B3-8CE102100932}"/>
              </a:ext>
            </a:extLst>
          </p:cNvPr>
          <p:cNvSpPr/>
          <p:nvPr/>
        </p:nvSpPr>
        <p:spPr>
          <a:xfrm>
            <a:off x="5809487" y="1844668"/>
            <a:ext cx="1554480" cy="1168442"/>
          </a:xfrm>
          <a:prstGeom prst="roundRect">
            <a:avLst>
              <a:gd name="adj" fmla="val 10792"/>
            </a:avLst>
          </a:prstGeom>
          <a:gradFill>
            <a:gsLst>
              <a:gs pos="100000">
                <a:srgbClr val="F0EDF3">
                  <a:alpha val="0"/>
                </a:srgbClr>
              </a:gs>
              <a:gs pos="0">
                <a:srgbClr val="FFFFFF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Rectangle: Rounded Corners 220">
            <a:extLst>
              <a:ext uri="{FF2B5EF4-FFF2-40B4-BE49-F238E27FC236}">
                <a16:creationId xmlns:a16="http://schemas.microsoft.com/office/drawing/2014/main" id="{7C1EF2AF-7FF3-0671-B089-0CF712EC68E1}"/>
              </a:ext>
            </a:extLst>
          </p:cNvPr>
          <p:cNvSpPr/>
          <p:nvPr/>
        </p:nvSpPr>
        <p:spPr>
          <a:xfrm>
            <a:off x="261981" y="1845475"/>
            <a:ext cx="1554480" cy="1202916"/>
          </a:xfrm>
          <a:prstGeom prst="roundRect">
            <a:avLst>
              <a:gd name="adj" fmla="val 10792"/>
            </a:avLst>
          </a:prstGeom>
          <a:gradFill>
            <a:gsLst>
              <a:gs pos="100000">
                <a:srgbClr val="F0EDF3">
                  <a:alpha val="0"/>
                </a:srgbClr>
              </a:gs>
              <a:gs pos="30000">
                <a:srgbClr val="FFFFFF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B7964B61-3040-C845-EC68-AAED303A0FC0}"/>
              </a:ext>
            </a:extLst>
          </p:cNvPr>
          <p:cNvSpPr/>
          <p:nvPr/>
        </p:nvSpPr>
        <p:spPr>
          <a:xfrm>
            <a:off x="0" y="0"/>
            <a:ext cx="7620000" cy="241991"/>
          </a:xfrm>
          <a:prstGeom prst="rect">
            <a:avLst/>
          </a:prstGeom>
          <a:solidFill>
            <a:schemeClr val="accent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Rectangle: Top Corners Rounded 182">
            <a:extLst>
              <a:ext uri="{FF2B5EF4-FFF2-40B4-BE49-F238E27FC236}">
                <a16:creationId xmlns:a16="http://schemas.microsoft.com/office/drawing/2014/main" id="{5F6B6266-BAB9-7B65-3863-34C37A715405}"/>
              </a:ext>
            </a:extLst>
          </p:cNvPr>
          <p:cNvSpPr/>
          <p:nvPr/>
        </p:nvSpPr>
        <p:spPr>
          <a:xfrm>
            <a:off x="4458676" y="451818"/>
            <a:ext cx="935459" cy="697981"/>
          </a:xfrm>
          <a:prstGeom prst="round2SameRect">
            <a:avLst>
              <a:gd name="adj1" fmla="val 13142"/>
              <a:gd name="adj2" fmla="val 0"/>
            </a:avLst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Arrow: Pentagon 179">
            <a:extLst>
              <a:ext uri="{FF2B5EF4-FFF2-40B4-BE49-F238E27FC236}">
                <a16:creationId xmlns:a16="http://schemas.microsoft.com/office/drawing/2014/main" id="{6FB15E55-21D1-435E-7536-8AEB0CF6BFF8}"/>
              </a:ext>
            </a:extLst>
          </p:cNvPr>
          <p:cNvSpPr/>
          <p:nvPr/>
        </p:nvSpPr>
        <p:spPr>
          <a:xfrm>
            <a:off x="4225771" y="1042811"/>
            <a:ext cx="1297622" cy="436691"/>
          </a:xfrm>
          <a:prstGeom prst="homePlate">
            <a:avLst>
              <a:gd name="adj" fmla="val 26189"/>
            </a:avLst>
          </a:prstGeom>
          <a:gradFill>
            <a:gsLst>
              <a:gs pos="0">
                <a:schemeClr val="accent1"/>
              </a:gs>
              <a:gs pos="100000">
                <a:schemeClr val="accent2"/>
              </a:gs>
            </a:gsLst>
            <a:lin ang="21594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786A636-E0E8-E7D6-6C90-1E05C12AED71}"/>
              </a:ext>
            </a:extLst>
          </p:cNvPr>
          <p:cNvSpPr txBox="1"/>
          <p:nvPr/>
        </p:nvSpPr>
        <p:spPr>
          <a:xfrm>
            <a:off x="0" y="-7583"/>
            <a:ext cx="7620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tlecitinib</a:t>
            </a:r>
            <a:r>
              <a:rPr lang="en-US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JAK3/TEC family kinase inhibitor, stabilizes active lesions and repigments stable lesions in patients with vitiligo </a:t>
            </a:r>
          </a:p>
        </p:txBody>
      </p:sp>
      <p:sp>
        <p:nvSpPr>
          <p:cNvPr id="15" name="Rectangle: Top Corners Rounded 14">
            <a:extLst>
              <a:ext uri="{FF2B5EF4-FFF2-40B4-BE49-F238E27FC236}">
                <a16:creationId xmlns:a16="http://schemas.microsoft.com/office/drawing/2014/main" id="{D32E67FA-3989-E82C-2990-7B2B65414E66}"/>
              </a:ext>
            </a:extLst>
          </p:cNvPr>
          <p:cNvSpPr/>
          <p:nvPr/>
        </p:nvSpPr>
        <p:spPr>
          <a:xfrm rot="5400000">
            <a:off x="587405" y="-255975"/>
            <a:ext cx="1133385" cy="2308197"/>
          </a:xfrm>
          <a:prstGeom prst="round2SameRect">
            <a:avLst>
              <a:gd name="adj1" fmla="val 13142"/>
              <a:gd name="adj2" fmla="val 0"/>
            </a:avLst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741C6E3-31B2-7611-4966-AAC7AFBADEF2}"/>
              </a:ext>
            </a:extLst>
          </p:cNvPr>
          <p:cNvSpPr txBox="1"/>
          <p:nvPr/>
        </p:nvSpPr>
        <p:spPr>
          <a:xfrm>
            <a:off x="71576" y="382598"/>
            <a:ext cx="2174474" cy="10310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</a:pPr>
            <a:r>
              <a:rPr lang="en-US" sz="800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patients with vitiligo, melanocytes are attacked by the immune system, resulting in depigmented skin.</a:t>
            </a:r>
          </a:p>
          <a:p>
            <a:pPr>
              <a:spcBef>
                <a:spcPts val="600"/>
              </a:spcBef>
            </a:pPr>
            <a:r>
              <a:rPr lang="en-US" sz="8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jective: </a:t>
            </a:r>
            <a:r>
              <a:rPr lang="en-US" sz="8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 explore the effect of ritlecitinib on pigmentation and pigment cell and immune biomarkers in active and stable vitiligo lesions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8D0FFB7-E602-6B67-FB0E-7537DB05DE0F}"/>
              </a:ext>
            </a:extLst>
          </p:cNvPr>
          <p:cNvSpPr txBox="1"/>
          <p:nvPr/>
        </p:nvSpPr>
        <p:spPr>
          <a:xfrm>
            <a:off x="-1" y="1536740"/>
            <a:ext cx="381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fore ritlecitinib treatment (active compared with stable lesions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F375941-80CA-E075-BC75-101EDB3B769A}"/>
              </a:ext>
            </a:extLst>
          </p:cNvPr>
          <p:cNvSpPr txBox="1"/>
          <p:nvPr/>
        </p:nvSpPr>
        <p:spPr>
          <a:xfrm>
            <a:off x="3810000" y="1529788"/>
            <a:ext cx="381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fter 24 weeks ritlecitinib treatment (versus before treatment)</a:t>
            </a:r>
          </a:p>
        </p:txBody>
      </p:sp>
      <p:sp>
        <p:nvSpPr>
          <p:cNvPr id="202" name="Rectangle: Rounded Corners 201">
            <a:extLst>
              <a:ext uri="{FF2B5EF4-FFF2-40B4-BE49-F238E27FC236}">
                <a16:creationId xmlns:a16="http://schemas.microsoft.com/office/drawing/2014/main" id="{CFCDC73C-ADCE-80EC-3FF6-2013FC58641A}"/>
              </a:ext>
            </a:extLst>
          </p:cNvPr>
          <p:cNvSpPr/>
          <p:nvPr/>
        </p:nvSpPr>
        <p:spPr>
          <a:xfrm>
            <a:off x="261412" y="1845084"/>
            <a:ext cx="1554480" cy="1188720"/>
          </a:xfrm>
          <a:prstGeom prst="roundRect">
            <a:avLst>
              <a:gd name="adj" fmla="val 9307"/>
            </a:avLst>
          </a:prstGeom>
          <a:noFill/>
          <a:ln>
            <a:solidFill>
              <a:srgbClr val="66AF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5C741BB9-C663-F419-4AAF-8EA9815FE433}"/>
              </a:ext>
            </a:extLst>
          </p:cNvPr>
          <p:cNvGrpSpPr/>
          <p:nvPr/>
        </p:nvGrpSpPr>
        <p:grpSpPr>
          <a:xfrm>
            <a:off x="726673" y="1759830"/>
            <a:ext cx="270769" cy="270769"/>
            <a:chOff x="2472431" y="2428043"/>
            <a:chExt cx="270769" cy="270769"/>
          </a:xfrm>
        </p:grpSpPr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0EED0731-2D81-676D-A4CF-2CED96790D28}"/>
                </a:ext>
              </a:extLst>
            </p:cNvPr>
            <p:cNvSpPr/>
            <p:nvPr/>
          </p:nvSpPr>
          <p:spPr>
            <a:xfrm>
              <a:off x="2472431" y="2428043"/>
              <a:ext cx="270769" cy="270769"/>
            </a:xfrm>
            <a:prstGeom prst="ellips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Graphic 22">
              <a:extLst>
                <a:ext uri="{FF2B5EF4-FFF2-40B4-BE49-F238E27FC236}">
                  <a16:creationId xmlns:a16="http://schemas.microsoft.com/office/drawing/2014/main" id="{D96B9500-04E1-38DD-AC26-FED7A6BA1356}"/>
                </a:ext>
              </a:extLst>
            </p:cNvPr>
            <p:cNvSpPr/>
            <p:nvPr/>
          </p:nvSpPr>
          <p:spPr>
            <a:xfrm>
              <a:off x="2500641" y="2487111"/>
              <a:ext cx="214349" cy="152633"/>
            </a:xfrm>
            <a:custGeom>
              <a:avLst/>
              <a:gdLst>
                <a:gd name="connsiteX0" fmla="*/ 239656 w 242427"/>
                <a:gd name="connsiteY0" fmla="*/ 33943 h 172627"/>
                <a:gd name="connsiteX1" fmla="*/ 239364 w 242427"/>
                <a:gd name="connsiteY1" fmla="*/ 33652 h 172627"/>
                <a:gd name="connsiteX2" fmla="*/ 238490 w 242427"/>
                <a:gd name="connsiteY2" fmla="*/ 33069 h 172627"/>
                <a:gd name="connsiteX3" fmla="*/ 238782 w 242427"/>
                <a:gd name="connsiteY3" fmla="*/ 32777 h 172627"/>
                <a:gd name="connsiteX4" fmla="*/ 238782 w 242427"/>
                <a:gd name="connsiteY4" fmla="*/ 18210 h 172627"/>
                <a:gd name="connsiteX5" fmla="*/ 238490 w 242427"/>
                <a:gd name="connsiteY5" fmla="*/ 17918 h 172627"/>
                <a:gd name="connsiteX6" fmla="*/ 237033 w 242427"/>
                <a:gd name="connsiteY6" fmla="*/ 16753 h 172627"/>
                <a:gd name="connsiteX7" fmla="*/ 234703 w 242427"/>
                <a:gd name="connsiteY7" fmla="*/ 5681 h 172627"/>
                <a:gd name="connsiteX8" fmla="*/ 234411 w 242427"/>
                <a:gd name="connsiteY8" fmla="*/ 5390 h 172627"/>
                <a:gd name="connsiteX9" fmla="*/ 221009 w 242427"/>
                <a:gd name="connsiteY9" fmla="*/ 4225 h 172627"/>
                <a:gd name="connsiteX10" fmla="*/ 220135 w 242427"/>
                <a:gd name="connsiteY10" fmla="*/ 3351 h 172627"/>
                <a:gd name="connsiteX11" fmla="*/ 219843 w 242427"/>
                <a:gd name="connsiteY11" fmla="*/ 3059 h 172627"/>
                <a:gd name="connsiteX12" fmla="*/ 205276 w 242427"/>
                <a:gd name="connsiteY12" fmla="*/ 3059 h 172627"/>
                <a:gd name="connsiteX13" fmla="*/ 182550 w 242427"/>
                <a:gd name="connsiteY13" fmla="*/ 24620 h 172627"/>
                <a:gd name="connsiteX14" fmla="*/ 182258 w 242427"/>
                <a:gd name="connsiteY14" fmla="*/ 24911 h 172627"/>
                <a:gd name="connsiteX15" fmla="*/ 183715 w 242427"/>
                <a:gd name="connsiteY15" fmla="*/ 14422 h 172627"/>
                <a:gd name="connsiteX16" fmla="*/ 175849 w 242427"/>
                <a:gd name="connsiteY16" fmla="*/ 2185 h 172627"/>
                <a:gd name="connsiteX17" fmla="*/ 175557 w 242427"/>
                <a:gd name="connsiteY17" fmla="*/ 2185 h 172627"/>
                <a:gd name="connsiteX18" fmla="*/ 163320 w 242427"/>
                <a:gd name="connsiteY18" fmla="*/ 10052 h 172627"/>
                <a:gd name="connsiteX19" fmla="*/ 156328 w 242427"/>
                <a:gd name="connsiteY19" fmla="*/ 36565 h 172627"/>
                <a:gd name="connsiteX20" fmla="*/ 147004 w 242427"/>
                <a:gd name="connsiteY20" fmla="*/ 72110 h 172627"/>
                <a:gd name="connsiteX21" fmla="*/ 103592 w 242427"/>
                <a:gd name="connsiteY21" fmla="*/ 103577 h 172627"/>
                <a:gd name="connsiteX22" fmla="*/ 47652 w 242427"/>
                <a:gd name="connsiteY22" fmla="*/ 46471 h 172627"/>
                <a:gd name="connsiteX23" fmla="*/ 40660 w 242427"/>
                <a:gd name="connsiteY23" fmla="*/ 45306 h 172627"/>
                <a:gd name="connsiteX24" fmla="*/ 39785 w 242427"/>
                <a:gd name="connsiteY24" fmla="*/ 51716 h 172627"/>
                <a:gd name="connsiteX25" fmla="*/ 99513 w 242427"/>
                <a:gd name="connsiteY25" fmla="*/ 112317 h 172627"/>
                <a:gd name="connsiteX26" fmla="*/ 105049 w 242427"/>
                <a:gd name="connsiteY26" fmla="*/ 112609 h 172627"/>
                <a:gd name="connsiteX27" fmla="*/ 154580 w 242427"/>
                <a:gd name="connsiteY27" fmla="*/ 76772 h 172627"/>
                <a:gd name="connsiteX28" fmla="*/ 155745 w 242427"/>
                <a:gd name="connsiteY28" fmla="*/ 71819 h 172627"/>
                <a:gd name="connsiteX29" fmla="*/ 163029 w 242427"/>
                <a:gd name="connsiteY29" fmla="*/ 41809 h 172627"/>
                <a:gd name="connsiteX30" fmla="*/ 164194 w 242427"/>
                <a:gd name="connsiteY30" fmla="*/ 39770 h 172627"/>
                <a:gd name="connsiteX31" fmla="*/ 171478 w 242427"/>
                <a:gd name="connsiteY31" fmla="*/ 12091 h 172627"/>
                <a:gd name="connsiteX32" fmla="*/ 172644 w 242427"/>
                <a:gd name="connsiteY32" fmla="*/ 11217 h 172627"/>
                <a:gd name="connsiteX33" fmla="*/ 172935 w 242427"/>
                <a:gd name="connsiteY33" fmla="*/ 11217 h 172627"/>
                <a:gd name="connsiteX34" fmla="*/ 173809 w 242427"/>
                <a:gd name="connsiteY34" fmla="*/ 12383 h 172627"/>
                <a:gd name="connsiteX35" fmla="*/ 173809 w 242427"/>
                <a:gd name="connsiteY35" fmla="*/ 12674 h 172627"/>
                <a:gd name="connsiteX36" fmla="*/ 171187 w 242427"/>
                <a:gd name="connsiteY36" fmla="*/ 33360 h 172627"/>
                <a:gd name="connsiteX37" fmla="*/ 173809 w 242427"/>
                <a:gd name="connsiteY37" fmla="*/ 38313 h 172627"/>
                <a:gd name="connsiteX38" fmla="*/ 178762 w 242427"/>
                <a:gd name="connsiteY38" fmla="*/ 38313 h 172627"/>
                <a:gd name="connsiteX39" fmla="*/ 188086 w 242427"/>
                <a:gd name="connsiteY39" fmla="*/ 32195 h 172627"/>
                <a:gd name="connsiteX40" fmla="*/ 188960 w 242427"/>
                <a:gd name="connsiteY40" fmla="*/ 31612 h 172627"/>
                <a:gd name="connsiteX41" fmla="*/ 211394 w 242427"/>
                <a:gd name="connsiteY41" fmla="*/ 8886 h 172627"/>
                <a:gd name="connsiteX42" fmla="*/ 212851 w 242427"/>
                <a:gd name="connsiteY42" fmla="*/ 8886 h 172627"/>
                <a:gd name="connsiteX43" fmla="*/ 213142 w 242427"/>
                <a:gd name="connsiteY43" fmla="*/ 9178 h 172627"/>
                <a:gd name="connsiteX44" fmla="*/ 213142 w 242427"/>
                <a:gd name="connsiteY44" fmla="*/ 10634 h 172627"/>
                <a:gd name="connsiteX45" fmla="*/ 190416 w 242427"/>
                <a:gd name="connsiteY45" fmla="*/ 33360 h 172627"/>
                <a:gd name="connsiteX46" fmla="*/ 190416 w 242427"/>
                <a:gd name="connsiteY46" fmla="*/ 40061 h 172627"/>
                <a:gd name="connsiteX47" fmla="*/ 193621 w 242427"/>
                <a:gd name="connsiteY47" fmla="*/ 41518 h 172627"/>
                <a:gd name="connsiteX48" fmla="*/ 196826 w 242427"/>
                <a:gd name="connsiteY48" fmla="*/ 40061 h 172627"/>
                <a:gd name="connsiteX49" fmla="*/ 225671 w 242427"/>
                <a:gd name="connsiteY49" fmla="*/ 11509 h 172627"/>
                <a:gd name="connsiteX50" fmla="*/ 227127 w 242427"/>
                <a:gd name="connsiteY50" fmla="*/ 11509 h 172627"/>
                <a:gd name="connsiteX51" fmla="*/ 227419 w 242427"/>
                <a:gd name="connsiteY51" fmla="*/ 11800 h 172627"/>
                <a:gd name="connsiteX52" fmla="*/ 227419 w 242427"/>
                <a:gd name="connsiteY52" fmla="*/ 13257 h 172627"/>
                <a:gd name="connsiteX53" fmla="*/ 198283 w 242427"/>
                <a:gd name="connsiteY53" fmla="*/ 42392 h 172627"/>
                <a:gd name="connsiteX54" fmla="*/ 198283 w 242427"/>
                <a:gd name="connsiteY54" fmla="*/ 49093 h 172627"/>
                <a:gd name="connsiteX55" fmla="*/ 204984 w 242427"/>
                <a:gd name="connsiteY55" fmla="*/ 49093 h 172627"/>
                <a:gd name="connsiteX56" fmla="*/ 229750 w 242427"/>
                <a:gd name="connsiteY56" fmla="*/ 24328 h 172627"/>
                <a:gd name="connsiteX57" fmla="*/ 231206 w 242427"/>
                <a:gd name="connsiteY57" fmla="*/ 24328 h 172627"/>
                <a:gd name="connsiteX58" fmla="*/ 231498 w 242427"/>
                <a:gd name="connsiteY58" fmla="*/ 24620 h 172627"/>
                <a:gd name="connsiteX59" fmla="*/ 231498 w 242427"/>
                <a:gd name="connsiteY59" fmla="*/ 26076 h 172627"/>
                <a:gd name="connsiteX60" fmla="*/ 206441 w 242427"/>
                <a:gd name="connsiteY60" fmla="*/ 51424 h 172627"/>
                <a:gd name="connsiteX61" fmla="*/ 206441 w 242427"/>
                <a:gd name="connsiteY61" fmla="*/ 58125 h 172627"/>
                <a:gd name="connsiteX62" fmla="*/ 213142 w 242427"/>
                <a:gd name="connsiteY62" fmla="*/ 58125 h 172627"/>
                <a:gd name="connsiteX63" fmla="*/ 230915 w 242427"/>
                <a:gd name="connsiteY63" fmla="*/ 40353 h 172627"/>
                <a:gd name="connsiteX64" fmla="*/ 232372 w 242427"/>
                <a:gd name="connsiteY64" fmla="*/ 40353 h 172627"/>
                <a:gd name="connsiteX65" fmla="*/ 232663 w 242427"/>
                <a:gd name="connsiteY65" fmla="*/ 40644 h 172627"/>
                <a:gd name="connsiteX66" fmla="*/ 232663 w 242427"/>
                <a:gd name="connsiteY66" fmla="*/ 42101 h 172627"/>
                <a:gd name="connsiteX67" fmla="*/ 213725 w 242427"/>
                <a:gd name="connsiteY67" fmla="*/ 61039 h 172627"/>
                <a:gd name="connsiteX68" fmla="*/ 191873 w 242427"/>
                <a:gd name="connsiteY68" fmla="*/ 80851 h 172627"/>
                <a:gd name="connsiteX69" fmla="*/ 177888 w 242427"/>
                <a:gd name="connsiteY69" fmla="*/ 86678 h 172627"/>
                <a:gd name="connsiteX70" fmla="*/ 173809 w 242427"/>
                <a:gd name="connsiteY70" fmla="*/ 88135 h 172627"/>
                <a:gd name="connsiteX71" fmla="*/ 148170 w 242427"/>
                <a:gd name="connsiteY71" fmla="*/ 117853 h 172627"/>
                <a:gd name="connsiteX72" fmla="*/ 107963 w 242427"/>
                <a:gd name="connsiteY72" fmla="*/ 156312 h 172627"/>
                <a:gd name="connsiteX73" fmla="*/ 104466 w 242427"/>
                <a:gd name="connsiteY73" fmla="*/ 159226 h 172627"/>
                <a:gd name="connsiteX74" fmla="*/ 97474 w 242427"/>
                <a:gd name="connsiteY74" fmla="*/ 163305 h 172627"/>
                <a:gd name="connsiteX75" fmla="*/ 90481 w 242427"/>
                <a:gd name="connsiteY75" fmla="*/ 159226 h 172627"/>
                <a:gd name="connsiteX76" fmla="*/ 7736 w 242427"/>
                <a:gd name="connsiteY76" fmla="*/ 91340 h 172627"/>
                <a:gd name="connsiteX77" fmla="*/ 1035 w 242427"/>
                <a:gd name="connsiteY77" fmla="*/ 91923 h 172627"/>
                <a:gd name="connsiteX78" fmla="*/ 1909 w 242427"/>
                <a:gd name="connsiteY78" fmla="*/ 98915 h 172627"/>
                <a:gd name="connsiteX79" fmla="*/ 84946 w 242427"/>
                <a:gd name="connsiteY79" fmla="*/ 166801 h 172627"/>
                <a:gd name="connsiteX80" fmla="*/ 97474 w 242427"/>
                <a:gd name="connsiteY80" fmla="*/ 172628 h 172627"/>
                <a:gd name="connsiteX81" fmla="*/ 98057 w 242427"/>
                <a:gd name="connsiteY81" fmla="*/ 172628 h 172627"/>
                <a:gd name="connsiteX82" fmla="*/ 110585 w 242427"/>
                <a:gd name="connsiteY82" fmla="*/ 166218 h 172627"/>
                <a:gd name="connsiteX83" fmla="*/ 113498 w 242427"/>
                <a:gd name="connsiteY83" fmla="*/ 163887 h 172627"/>
                <a:gd name="connsiteX84" fmla="*/ 155454 w 242427"/>
                <a:gd name="connsiteY84" fmla="*/ 123680 h 172627"/>
                <a:gd name="connsiteX85" fmla="*/ 179345 w 242427"/>
                <a:gd name="connsiteY85" fmla="*/ 96002 h 172627"/>
                <a:gd name="connsiteX86" fmla="*/ 198283 w 242427"/>
                <a:gd name="connsiteY86" fmla="*/ 87552 h 172627"/>
                <a:gd name="connsiteX87" fmla="*/ 219843 w 242427"/>
                <a:gd name="connsiteY87" fmla="*/ 68031 h 172627"/>
                <a:gd name="connsiteX88" fmla="*/ 220135 w 242427"/>
                <a:gd name="connsiteY88" fmla="*/ 67740 h 172627"/>
                <a:gd name="connsiteX89" fmla="*/ 239073 w 242427"/>
                <a:gd name="connsiteY89" fmla="*/ 48511 h 172627"/>
                <a:gd name="connsiteX90" fmla="*/ 239656 w 242427"/>
                <a:gd name="connsiteY90" fmla="*/ 33943 h 172627"/>
                <a:gd name="connsiteX91" fmla="*/ 239656 w 242427"/>
                <a:gd name="connsiteY91" fmla="*/ 33943 h 1726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</a:cxnLst>
              <a:rect l="l" t="t" r="r" b="b"/>
              <a:pathLst>
                <a:path w="242427" h="172627">
                  <a:moveTo>
                    <a:pt x="239656" y="33943"/>
                  </a:moveTo>
                  <a:lnTo>
                    <a:pt x="239364" y="33652"/>
                  </a:lnTo>
                  <a:cubicBezTo>
                    <a:pt x="239073" y="33360"/>
                    <a:pt x="238782" y="33069"/>
                    <a:pt x="238490" y="33069"/>
                  </a:cubicBezTo>
                  <a:lnTo>
                    <a:pt x="238782" y="32777"/>
                  </a:lnTo>
                  <a:cubicBezTo>
                    <a:pt x="242861" y="28698"/>
                    <a:pt x="242861" y="21997"/>
                    <a:pt x="238782" y="18210"/>
                  </a:cubicBezTo>
                  <a:lnTo>
                    <a:pt x="238490" y="17918"/>
                  </a:lnTo>
                  <a:cubicBezTo>
                    <a:pt x="237907" y="17336"/>
                    <a:pt x="237616" y="17044"/>
                    <a:pt x="237033" y="16753"/>
                  </a:cubicBezTo>
                  <a:cubicBezTo>
                    <a:pt x="238490" y="12965"/>
                    <a:pt x="237616" y="8595"/>
                    <a:pt x="234703" y="5681"/>
                  </a:cubicBezTo>
                  <a:lnTo>
                    <a:pt x="234411" y="5390"/>
                  </a:lnTo>
                  <a:cubicBezTo>
                    <a:pt x="230915" y="1894"/>
                    <a:pt x="225088" y="1311"/>
                    <a:pt x="221009" y="4225"/>
                  </a:cubicBezTo>
                  <a:cubicBezTo>
                    <a:pt x="220717" y="3933"/>
                    <a:pt x="220426" y="3642"/>
                    <a:pt x="220135" y="3351"/>
                  </a:cubicBezTo>
                  <a:lnTo>
                    <a:pt x="219843" y="3059"/>
                  </a:lnTo>
                  <a:cubicBezTo>
                    <a:pt x="215764" y="-1020"/>
                    <a:pt x="209063" y="-1020"/>
                    <a:pt x="205276" y="3059"/>
                  </a:cubicBezTo>
                  <a:lnTo>
                    <a:pt x="182550" y="24620"/>
                  </a:lnTo>
                  <a:lnTo>
                    <a:pt x="182258" y="24911"/>
                  </a:lnTo>
                  <a:lnTo>
                    <a:pt x="183715" y="14422"/>
                  </a:lnTo>
                  <a:cubicBezTo>
                    <a:pt x="184881" y="8886"/>
                    <a:pt x="181384" y="3351"/>
                    <a:pt x="175849" y="2185"/>
                  </a:cubicBezTo>
                  <a:lnTo>
                    <a:pt x="175557" y="2185"/>
                  </a:lnTo>
                  <a:cubicBezTo>
                    <a:pt x="170022" y="1020"/>
                    <a:pt x="164486" y="4516"/>
                    <a:pt x="163320" y="10052"/>
                  </a:cubicBezTo>
                  <a:lnTo>
                    <a:pt x="156328" y="36565"/>
                  </a:lnTo>
                  <a:cubicBezTo>
                    <a:pt x="143800" y="50259"/>
                    <a:pt x="145548" y="65409"/>
                    <a:pt x="147004" y="72110"/>
                  </a:cubicBezTo>
                  <a:cubicBezTo>
                    <a:pt x="142051" y="76189"/>
                    <a:pt x="128649" y="86678"/>
                    <a:pt x="103592" y="103577"/>
                  </a:cubicBezTo>
                  <a:cubicBezTo>
                    <a:pt x="94852" y="95710"/>
                    <a:pt x="65716" y="69488"/>
                    <a:pt x="47652" y="46471"/>
                  </a:cubicBezTo>
                  <a:cubicBezTo>
                    <a:pt x="45613" y="44140"/>
                    <a:pt x="42699" y="43849"/>
                    <a:pt x="40660" y="45306"/>
                  </a:cubicBezTo>
                  <a:cubicBezTo>
                    <a:pt x="38620" y="46763"/>
                    <a:pt x="38329" y="49967"/>
                    <a:pt x="39785" y="51716"/>
                  </a:cubicBezTo>
                  <a:cubicBezTo>
                    <a:pt x="61637" y="79686"/>
                    <a:pt x="98057" y="111152"/>
                    <a:pt x="99513" y="112317"/>
                  </a:cubicBezTo>
                  <a:cubicBezTo>
                    <a:pt x="100970" y="113774"/>
                    <a:pt x="103301" y="113774"/>
                    <a:pt x="105049" y="112609"/>
                  </a:cubicBezTo>
                  <a:cubicBezTo>
                    <a:pt x="140303" y="89009"/>
                    <a:pt x="153997" y="77063"/>
                    <a:pt x="154580" y="76772"/>
                  </a:cubicBezTo>
                  <a:cubicBezTo>
                    <a:pt x="156036" y="75607"/>
                    <a:pt x="156619" y="73567"/>
                    <a:pt x="155745" y="71819"/>
                  </a:cubicBezTo>
                  <a:cubicBezTo>
                    <a:pt x="155454" y="71236"/>
                    <a:pt x="149918" y="55212"/>
                    <a:pt x="163029" y="41809"/>
                  </a:cubicBezTo>
                  <a:cubicBezTo>
                    <a:pt x="163612" y="41227"/>
                    <a:pt x="163903" y="40644"/>
                    <a:pt x="164194" y="39770"/>
                  </a:cubicBezTo>
                  <a:lnTo>
                    <a:pt x="171478" y="12091"/>
                  </a:lnTo>
                  <a:cubicBezTo>
                    <a:pt x="171478" y="11509"/>
                    <a:pt x="172061" y="11217"/>
                    <a:pt x="172644" y="11217"/>
                  </a:cubicBezTo>
                  <a:lnTo>
                    <a:pt x="172935" y="11217"/>
                  </a:lnTo>
                  <a:cubicBezTo>
                    <a:pt x="173518" y="11217"/>
                    <a:pt x="173809" y="11800"/>
                    <a:pt x="173809" y="12383"/>
                  </a:cubicBezTo>
                  <a:lnTo>
                    <a:pt x="173809" y="12674"/>
                  </a:lnTo>
                  <a:lnTo>
                    <a:pt x="171187" y="33360"/>
                  </a:lnTo>
                  <a:cubicBezTo>
                    <a:pt x="171478" y="35400"/>
                    <a:pt x="172061" y="37148"/>
                    <a:pt x="173809" y="38313"/>
                  </a:cubicBezTo>
                  <a:cubicBezTo>
                    <a:pt x="175266" y="39187"/>
                    <a:pt x="177305" y="39187"/>
                    <a:pt x="178762" y="38313"/>
                  </a:cubicBezTo>
                  <a:lnTo>
                    <a:pt x="188086" y="32195"/>
                  </a:lnTo>
                  <a:cubicBezTo>
                    <a:pt x="188377" y="31903"/>
                    <a:pt x="188668" y="31903"/>
                    <a:pt x="188960" y="31612"/>
                  </a:cubicBezTo>
                  <a:lnTo>
                    <a:pt x="211394" y="8886"/>
                  </a:lnTo>
                  <a:cubicBezTo>
                    <a:pt x="211685" y="8595"/>
                    <a:pt x="212559" y="8595"/>
                    <a:pt x="212851" y="8886"/>
                  </a:cubicBezTo>
                  <a:lnTo>
                    <a:pt x="213142" y="9178"/>
                  </a:lnTo>
                  <a:cubicBezTo>
                    <a:pt x="213434" y="9469"/>
                    <a:pt x="213434" y="10052"/>
                    <a:pt x="213142" y="10634"/>
                  </a:cubicBezTo>
                  <a:lnTo>
                    <a:pt x="190416" y="33360"/>
                  </a:lnTo>
                  <a:cubicBezTo>
                    <a:pt x="188668" y="35108"/>
                    <a:pt x="188668" y="38022"/>
                    <a:pt x="190416" y="40061"/>
                  </a:cubicBezTo>
                  <a:cubicBezTo>
                    <a:pt x="191291" y="40935"/>
                    <a:pt x="192456" y="41518"/>
                    <a:pt x="193621" y="41518"/>
                  </a:cubicBezTo>
                  <a:cubicBezTo>
                    <a:pt x="194787" y="41518"/>
                    <a:pt x="195952" y="40935"/>
                    <a:pt x="196826" y="40061"/>
                  </a:cubicBezTo>
                  <a:lnTo>
                    <a:pt x="225671" y="11509"/>
                  </a:lnTo>
                  <a:cubicBezTo>
                    <a:pt x="225962" y="11217"/>
                    <a:pt x="226836" y="11217"/>
                    <a:pt x="227127" y="11509"/>
                  </a:cubicBezTo>
                  <a:lnTo>
                    <a:pt x="227419" y="11800"/>
                  </a:lnTo>
                  <a:cubicBezTo>
                    <a:pt x="227710" y="12091"/>
                    <a:pt x="227710" y="12965"/>
                    <a:pt x="227419" y="13257"/>
                  </a:cubicBezTo>
                  <a:lnTo>
                    <a:pt x="198283" y="42392"/>
                  </a:lnTo>
                  <a:cubicBezTo>
                    <a:pt x="196535" y="44140"/>
                    <a:pt x="196535" y="47054"/>
                    <a:pt x="198283" y="49093"/>
                  </a:cubicBezTo>
                  <a:cubicBezTo>
                    <a:pt x="200031" y="50841"/>
                    <a:pt x="202945" y="50841"/>
                    <a:pt x="204984" y="49093"/>
                  </a:cubicBezTo>
                  <a:lnTo>
                    <a:pt x="229750" y="24328"/>
                  </a:lnTo>
                  <a:cubicBezTo>
                    <a:pt x="230041" y="24037"/>
                    <a:pt x="230915" y="24037"/>
                    <a:pt x="231206" y="24328"/>
                  </a:cubicBezTo>
                  <a:lnTo>
                    <a:pt x="231498" y="24620"/>
                  </a:lnTo>
                  <a:cubicBezTo>
                    <a:pt x="231789" y="24911"/>
                    <a:pt x="231789" y="25785"/>
                    <a:pt x="231498" y="26076"/>
                  </a:cubicBezTo>
                  <a:lnTo>
                    <a:pt x="206441" y="51424"/>
                  </a:lnTo>
                  <a:cubicBezTo>
                    <a:pt x="204693" y="53172"/>
                    <a:pt x="204693" y="56086"/>
                    <a:pt x="206441" y="58125"/>
                  </a:cubicBezTo>
                  <a:cubicBezTo>
                    <a:pt x="208189" y="59874"/>
                    <a:pt x="211103" y="59874"/>
                    <a:pt x="213142" y="58125"/>
                  </a:cubicBezTo>
                  <a:lnTo>
                    <a:pt x="230915" y="40353"/>
                  </a:lnTo>
                  <a:cubicBezTo>
                    <a:pt x="231206" y="40061"/>
                    <a:pt x="232080" y="40061"/>
                    <a:pt x="232372" y="40353"/>
                  </a:cubicBezTo>
                  <a:lnTo>
                    <a:pt x="232663" y="40644"/>
                  </a:lnTo>
                  <a:cubicBezTo>
                    <a:pt x="232954" y="40935"/>
                    <a:pt x="232954" y="41809"/>
                    <a:pt x="232663" y="42101"/>
                  </a:cubicBezTo>
                  <a:lnTo>
                    <a:pt x="213725" y="61039"/>
                  </a:lnTo>
                  <a:lnTo>
                    <a:pt x="191873" y="80851"/>
                  </a:lnTo>
                  <a:cubicBezTo>
                    <a:pt x="189834" y="82599"/>
                    <a:pt x="183424" y="87552"/>
                    <a:pt x="177888" y="86678"/>
                  </a:cubicBezTo>
                  <a:cubicBezTo>
                    <a:pt x="176431" y="86387"/>
                    <a:pt x="174683" y="86970"/>
                    <a:pt x="173809" y="88135"/>
                  </a:cubicBezTo>
                  <a:cubicBezTo>
                    <a:pt x="162446" y="100663"/>
                    <a:pt x="154580" y="110278"/>
                    <a:pt x="148170" y="117853"/>
                  </a:cubicBezTo>
                  <a:cubicBezTo>
                    <a:pt x="134476" y="134169"/>
                    <a:pt x="127484" y="142618"/>
                    <a:pt x="107963" y="156312"/>
                  </a:cubicBezTo>
                  <a:cubicBezTo>
                    <a:pt x="106797" y="157186"/>
                    <a:pt x="105632" y="158060"/>
                    <a:pt x="104466" y="159226"/>
                  </a:cubicBezTo>
                  <a:cubicBezTo>
                    <a:pt x="102136" y="161265"/>
                    <a:pt x="99805" y="163305"/>
                    <a:pt x="97474" y="163305"/>
                  </a:cubicBezTo>
                  <a:cubicBezTo>
                    <a:pt x="95434" y="163305"/>
                    <a:pt x="92812" y="161265"/>
                    <a:pt x="90481" y="159226"/>
                  </a:cubicBezTo>
                  <a:cubicBezTo>
                    <a:pt x="82032" y="152524"/>
                    <a:pt x="8610" y="92214"/>
                    <a:pt x="7736" y="91340"/>
                  </a:cubicBezTo>
                  <a:cubicBezTo>
                    <a:pt x="5697" y="89592"/>
                    <a:pt x="2783" y="89883"/>
                    <a:pt x="1035" y="91923"/>
                  </a:cubicBezTo>
                  <a:cubicBezTo>
                    <a:pt x="-713" y="93962"/>
                    <a:pt x="-130" y="97458"/>
                    <a:pt x="1909" y="98915"/>
                  </a:cubicBezTo>
                  <a:cubicBezTo>
                    <a:pt x="2783" y="99498"/>
                    <a:pt x="76205" y="160100"/>
                    <a:pt x="84946" y="166801"/>
                  </a:cubicBezTo>
                  <a:cubicBezTo>
                    <a:pt x="88151" y="169423"/>
                    <a:pt x="92230" y="172628"/>
                    <a:pt x="97474" y="172628"/>
                  </a:cubicBezTo>
                  <a:lnTo>
                    <a:pt x="98057" y="172628"/>
                  </a:lnTo>
                  <a:cubicBezTo>
                    <a:pt x="103301" y="172337"/>
                    <a:pt x="107380" y="168840"/>
                    <a:pt x="110585" y="166218"/>
                  </a:cubicBezTo>
                  <a:cubicBezTo>
                    <a:pt x="111459" y="165344"/>
                    <a:pt x="112624" y="164470"/>
                    <a:pt x="113498" y="163887"/>
                  </a:cubicBezTo>
                  <a:cubicBezTo>
                    <a:pt x="133893" y="149320"/>
                    <a:pt x="141760" y="140288"/>
                    <a:pt x="155454" y="123680"/>
                  </a:cubicBezTo>
                  <a:cubicBezTo>
                    <a:pt x="161572" y="116396"/>
                    <a:pt x="169147" y="107656"/>
                    <a:pt x="179345" y="96002"/>
                  </a:cubicBezTo>
                  <a:cubicBezTo>
                    <a:pt x="188960" y="96002"/>
                    <a:pt x="197409" y="88426"/>
                    <a:pt x="198283" y="87552"/>
                  </a:cubicBezTo>
                  <a:lnTo>
                    <a:pt x="219843" y="68031"/>
                  </a:lnTo>
                  <a:cubicBezTo>
                    <a:pt x="220135" y="68031"/>
                    <a:pt x="220135" y="67740"/>
                    <a:pt x="220135" y="67740"/>
                  </a:cubicBezTo>
                  <a:lnTo>
                    <a:pt x="239073" y="48511"/>
                  </a:lnTo>
                  <a:cubicBezTo>
                    <a:pt x="243443" y="44723"/>
                    <a:pt x="243443" y="38022"/>
                    <a:pt x="239656" y="33943"/>
                  </a:cubicBezTo>
                  <a:lnTo>
                    <a:pt x="239656" y="33943"/>
                  </a:lnTo>
                  <a:close/>
                </a:path>
              </a:pathLst>
            </a:custGeom>
            <a:solidFill>
              <a:schemeClr val="bg1"/>
            </a:solidFill>
            <a:ln w="239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03ACF3C7-7F8E-44EF-40FA-2DFE7DD311A6}"/>
              </a:ext>
            </a:extLst>
          </p:cNvPr>
          <p:cNvSpPr txBox="1"/>
          <p:nvPr/>
        </p:nvSpPr>
        <p:spPr>
          <a:xfrm>
            <a:off x="514489" y="2011774"/>
            <a:ext cx="1157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accent4">
                    <a:lumMod val="50000"/>
                  </a:schemeClr>
                </a:solidFill>
              </a:rPr>
              <a:t>Active lesions: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CD5E2D7B-3549-6F64-3AD9-BCAEA46B9171}"/>
              </a:ext>
            </a:extLst>
          </p:cNvPr>
          <p:cNvGrpSpPr/>
          <p:nvPr/>
        </p:nvGrpSpPr>
        <p:grpSpPr>
          <a:xfrm>
            <a:off x="297792" y="2227598"/>
            <a:ext cx="122103" cy="204870"/>
            <a:chOff x="248530" y="2050744"/>
            <a:chExt cx="122103" cy="204870"/>
          </a:xfrm>
        </p:grpSpPr>
        <p:sp>
          <p:nvSpPr>
            <p:cNvPr id="71" name="Arrow: Pentagon 70">
              <a:extLst>
                <a:ext uri="{FF2B5EF4-FFF2-40B4-BE49-F238E27FC236}">
                  <a16:creationId xmlns:a16="http://schemas.microsoft.com/office/drawing/2014/main" id="{4C3572C4-78C1-71BF-CAB8-5271CF82237B}"/>
                </a:ext>
              </a:extLst>
            </p:cNvPr>
            <p:cNvSpPr/>
            <p:nvPr/>
          </p:nvSpPr>
          <p:spPr>
            <a:xfrm rot="16200000">
              <a:off x="223427" y="2108408"/>
              <a:ext cx="172358" cy="122054"/>
            </a:xfrm>
            <a:prstGeom prst="homePlate">
              <a:avLst/>
            </a:prstGeom>
            <a:gradFill>
              <a:gsLst>
                <a:gs pos="0">
                  <a:srgbClr val="F0EDF3">
                    <a:alpha val="0"/>
                  </a:srgbClr>
                </a:gs>
                <a:gs pos="100000">
                  <a:schemeClr val="accent2"/>
                </a:gs>
              </a:gsLst>
              <a:lin ang="21594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0" name="Graphic 69">
              <a:extLst>
                <a:ext uri="{FF2B5EF4-FFF2-40B4-BE49-F238E27FC236}">
                  <a16:creationId xmlns:a16="http://schemas.microsoft.com/office/drawing/2014/main" id="{91E42B5E-6E26-72B2-7C2A-9068D14C61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5400000">
              <a:off x="258654" y="2040666"/>
              <a:ext cx="101898" cy="122054"/>
            </a:xfrm>
            <a:prstGeom prst="rect">
              <a:avLst/>
            </a:prstGeom>
          </p:spPr>
        </p:pic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EB6B196B-2781-70F2-8183-7D3F43086FCF}"/>
              </a:ext>
            </a:extLst>
          </p:cNvPr>
          <p:cNvSpPr txBox="1"/>
          <p:nvPr/>
        </p:nvSpPr>
        <p:spPr>
          <a:xfrm>
            <a:off x="483219" y="2227343"/>
            <a:ext cx="1345994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chemeClr val="accent2">
                    <a:lumMod val="50000"/>
                  </a:schemeClr>
                </a:solidFill>
              </a:rPr>
              <a:t>Inflammatory markers</a:t>
            </a:r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F8F37B4D-EEA6-7623-7330-09CC99FAC8D1}"/>
              </a:ext>
            </a:extLst>
          </p:cNvPr>
          <p:cNvGrpSpPr/>
          <p:nvPr/>
        </p:nvGrpSpPr>
        <p:grpSpPr>
          <a:xfrm>
            <a:off x="297838" y="2415462"/>
            <a:ext cx="1547373" cy="204870"/>
            <a:chOff x="238416" y="2295720"/>
            <a:chExt cx="1547373" cy="204870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FEBB311-075D-8369-B5DB-0DA2BADA3177}"/>
                </a:ext>
              </a:extLst>
            </p:cNvPr>
            <p:cNvSpPr txBox="1"/>
            <p:nvPr/>
          </p:nvSpPr>
          <p:spPr>
            <a:xfrm>
              <a:off x="423796" y="2302195"/>
              <a:ext cx="136199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chemeClr val="accent2">
                      <a:lumMod val="50000"/>
                    </a:schemeClr>
                  </a:solidFill>
                </a:rPr>
                <a:t>Immune T-cell markers</a:t>
              </a:r>
            </a:p>
          </p:txBody>
        </p: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7027C5A5-F76A-C7FC-4B01-16DFA3588515}"/>
                </a:ext>
              </a:extLst>
            </p:cNvPr>
            <p:cNvGrpSpPr/>
            <p:nvPr/>
          </p:nvGrpSpPr>
          <p:grpSpPr>
            <a:xfrm>
              <a:off x="238416" y="2295720"/>
              <a:ext cx="122057" cy="204870"/>
              <a:chOff x="248576" y="2050744"/>
              <a:chExt cx="122057" cy="204870"/>
            </a:xfrm>
          </p:grpSpPr>
          <p:sp>
            <p:nvSpPr>
              <p:cNvPr id="87" name="Arrow: Pentagon 86">
                <a:extLst>
                  <a:ext uri="{FF2B5EF4-FFF2-40B4-BE49-F238E27FC236}">
                    <a16:creationId xmlns:a16="http://schemas.microsoft.com/office/drawing/2014/main" id="{B62D3ACB-D32A-7A1B-89F6-834B223EB9FC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88" name="Graphic 87">
                <a:extLst>
                  <a:ext uri="{FF2B5EF4-FFF2-40B4-BE49-F238E27FC236}">
                    <a16:creationId xmlns:a16="http://schemas.microsoft.com/office/drawing/2014/main" id="{3AABCBE5-B928-79C6-3B69-FAE0F2778F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40666"/>
                <a:ext cx="101898" cy="122054"/>
              </a:xfrm>
              <a:prstGeom prst="rect">
                <a:avLst/>
              </a:prstGeom>
            </p:spPr>
          </p:pic>
        </p:grp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9DE0952-78D3-99A5-F250-6E539E76B6AA}"/>
              </a:ext>
            </a:extLst>
          </p:cNvPr>
          <p:cNvGrpSpPr/>
          <p:nvPr/>
        </p:nvGrpSpPr>
        <p:grpSpPr>
          <a:xfrm>
            <a:off x="297838" y="2603326"/>
            <a:ext cx="1146501" cy="204870"/>
            <a:chOff x="297838" y="2728010"/>
            <a:chExt cx="1146501" cy="204870"/>
          </a:xfrm>
        </p:grpSpPr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EE74E675-FCD2-E8C7-CE46-939D460F02F5}"/>
                </a:ext>
              </a:extLst>
            </p:cNvPr>
            <p:cNvSpPr txBox="1"/>
            <p:nvPr/>
          </p:nvSpPr>
          <p:spPr>
            <a:xfrm>
              <a:off x="483219" y="2742415"/>
              <a:ext cx="9611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chemeClr val="accent2">
                      <a:lumMod val="50000"/>
                    </a:schemeClr>
                  </a:solidFill>
                </a:rPr>
                <a:t>T-cell number</a:t>
              </a:r>
            </a:p>
          </p:txBody>
        </p: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018BEA66-9B08-D228-C93F-F31B6E11F2B1}"/>
                </a:ext>
              </a:extLst>
            </p:cNvPr>
            <p:cNvGrpSpPr/>
            <p:nvPr/>
          </p:nvGrpSpPr>
          <p:grpSpPr>
            <a:xfrm>
              <a:off x="297838" y="2728010"/>
              <a:ext cx="122057" cy="204870"/>
              <a:chOff x="248576" y="2050744"/>
              <a:chExt cx="122057" cy="204870"/>
            </a:xfrm>
          </p:grpSpPr>
          <p:sp>
            <p:nvSpPr>
              <p:cNvPr id="93" name="Arrow: Pentagon 92">
                <a:extLst>
                  <a:ext uri="{FF2B5EF4-FFF2-40B4-BE49-F238E27FC236}">
                    <a16:creationId xmlns:a16="http://schemas.microsoft.com/office/drawing/2014/main" id="{F50C6900-AE08-0823-99B1-3CD5C8EE1996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94" name="Graphic 93">
                <a:extLst>
                  <a:ext uri="{FF2B5EF4-FFF2-40B4-BE49-F238E27FC236}">
                    <a16:creationId xmlns:a16="http://schemas.microsoft.com/office/drawing/2014/main" id="{46FB4AC2-3C9B-60AE-8267-80D7595276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40666"/>
                <a:ext cx="101898" cy="122054"/>
              </a:xfrm>
              <a:prstGeom prst="rect">
                <a:avLst/>
              </a:prstGeom>
            </p:spPr>
          </p:pic>
        </p:grpSp>
      </p:grpSp>
      <p:sp>
        <p:nvSpPr>
          <p:cNvPr id="75" name="TextBox 74">
            <a:extLst>
              <a:ext uri="{FF2B5EF4-FFF2-40B4-BE49-F238E27FC236}">
                <a16:creationId xmlns:a16="http://schemas.microsoft.com/office/drawing/2014/main" id="{DC0694E2-78F3-3E1D-E255-8BF62F151592}"/>
              </a:ext>
            </a:extLst>
          </p:cNvPr>
          <p:cNvSpPr txBox="1"/>
          <p:nvPr/>
        </p:nvSpPr>
        <p:spPr>
          <a:xfrm>
            <a:off x="2066264" y="1994922"/>
            <a:ext cx="14183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chemeClr val="accent3">
                    <a:lumMod val="50000"/>
                  </a:schemeClr>
                </a:solidFill>
              </a:rPr>
              <a:t>Patients with more active than stable lesions: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07ED4A68-FDE0-3F39-9737-D45587FDE6BB}"/>
              </a:ext>
            </a:extLst>
          </p:cNvPr>
          <p:cNvSpPr txBox="1"/>
          <p:nvPr/>
        </p:nvSpPr>
        <p:spPr>
          <a:xfrm>
            <a:off x="2234548" y="2300795"/>
            <a:ext cx="129249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chemeClr val="accent2">
                    <a:lumMod val="50000"/>
                  </a:schemeClr>
                </a:solidFill>
              </a:rPr>
              <a:t>T-cell marker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B1F2B9A-DEB8-A4F1-1256-A3C0D7ABF1E0}"/>
              </a:ext>
            </a:extLst>
          </p:cNvPr>
          <p:cNvSpPr txBox="1"/>
          <p:nvPr/>
        </p:nvSpPr>
        <p:spPr>
          <a:xfrm>
            <a:off x="2234548" y="2482097"/>
            <a:ext cx="129249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chemeClr val="accent2">
                    <a:lumMod val="50000"/>
                  </a:schemeClr>
                </a:solidFill>
              </a:rPr>
              <a:t>T-cell activation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86D6F8ED-5CC4-6560-E1C7-5DA5C9C3670B}"/>
              </a:ext>
            </a:extLst>
          </p:cNvPr>
          <p:cNvSpPr txBox="1"/>
          <p:nvPr/>
        </p:nvSpPr>
        <p:spPr>
          <a:xfrm>
            <a:off x="2240718" y="2844701"/>
            <a:ext cx="129249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chemeClr val="accent2">
                    <a:lumMod val="50000"/>
                  </a:schemeClr>
                </a:solidFill>
              </a:rPr>
              <a:t>Antioxidants</a:t>
            </a:r>
          </a:p>
        </p:txBody>
      </p:sp>
      <p:sp>
        <p:nvSpPr>
          <p:cNvPr id="205" name="Rectangle: Rounded Corners 204">
            <a:extLst>
              <a:ext uri="{FF2B5EF4-FFF2-40B4-BE49-F238E27FC236}">
                <a16:creationId xmlns:a16="http://schemas.microsoft.com/office/drawing/2014/main" id="{45A13221-1FCB-F107-537D-F26FCF8CC70A}"/>
              </a:ext>
            </a:extLst>
          </p:cNvPr>
          <p:cNvSpPr/>
          <p:nvPr/>
        </p:nvSpPr>
        <p:spPr>
          <a:xfrm>
            <a:off x="5806797" y="1845084"/>
            <a:ext cx="1554480" cy="1188720"/>
          </a:xfrm>
          <a:prstGeom prst="roundRect">
            <a:avLst>
              <a:gd name="adj" fmla="val 9307"/>
            </a:avLst>
          </a:prstGeom>
          <a:noFill/>
          <a:ln>
            <a:solidFill>
              <a:srgbClr val="9AB5E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BA5F6017-9951-73A4-9027-49D367475BF4}"/>
              </a:ext>
            </a:extLst>
          </p:cNvPr>
          <p:cNvGrpSpPr/>
          <p:nvPr/>
        </p:nvGrpSpPr>
        <p:grpSpPr>
          <a:xfrm>
            <a:off x="6213875" y="1759830"/>
            <a:ext cx="270769" cy="270769"/>
            <a:chOff x="2895600" y="2445058"/>
            <a:chExt cx="270769" cy="270769"/>
          </a:xfrm>
        </p:grpSpPr>
        <p:sp>
          <p:nvSpPr>
            <p:cNvPr id="132" name="Oval 131">
              <a:extLst>
                <a:ext uri="{FF2B5EF4-FFF2-40B4-BE49-F238E27FC236}">
                  <a16:creationId xmlns:a16="http://schemas.microsoft.com/office/drawing/2014/main" id="{14332B43-85A3-204C-7158-E23FB7C2EF77}"/>
                </a:ext>
              </a:extLst>
            </p:cNvPr>
            <p:cNvSpPr/>
            <p:nvPr/>
          </p:nvSpPr>
          <p:spPr>
            <a:xfrm>
              <a:off x="2895600" y="2445058"/>
              <a:ext cx="270769" cy="270769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C43F1923-6D0D-1EEB-501E-CBC900D6ED12}"/>
                </a:ext>
              </a:extLst>
            </p:cNvPr>
            <p:cNvGrpSpPr/>
            <p:nvPr/>
          </p:nvGrpSpPr>
          <p:grpSpPr>
            <a:xfrm>
              <a:off x="2968471" y="2497107"/>
              <a:ext cx="125027" cy="166670"/>
              <a:chOff x="5652486" y="2326441"/>
              <a:chExt cx="125027" cy="166670"/>
            </a:xfrm>
            <a:solidFill>
              <a:schemeClr val="bg1"/>
            </a:solidFill>
          </p:grpSpPr>
          <p:sp>
            <p:nvSpPr>
              <p:cNvPr id="134" name="Freeform: Shape 133">
                <a:extLst>
                  <a:ext uri="{FF2B5EF4-FFF2-40B4-BE49-F238E27FC236}">
                    <a16:creationId xmlns:a16="http://schemas.microsoft.com/office/drawing/2014/main" id="{DA2695AD-038D-C8DE-8125-EA1311A6F05A}"/>
                  </a:ext>
                </a:extLst>
              </p:cNvPr>
              <p:cNvSpPr/>
              <p:nvPr/>
            </p:nvSpPr>
            <p:spPr>
              <a:xfrm>
                <a:off x="5652486" y="2326441"/>
                <a:ext cx="125027" cy="166670"/>
              </a:xfrm>
              <a:custGeom>
                <a:avLst/>
                <a:gdLst>
                  <a:gd name="connsiteX0" fmla="*/ 62514 w 125027"/>
                  <a:gd name="connsiteY0" fmla="*/ 166668 h 166670"/>
                  <a:gd name="connsiteX1" fmla="*/ 18587 w 125027"/>
                  <a:gd name="connsiteY1" fmla="*/ 148964 h 166670"/>
                  <a:gd name="connsiteX2" fmla="*/ 0 w 125027"/>
                  <a:gd name="connsiteY2" fmla="*/ 105405 h 166670"/>
                  <a:gd name="connsiteX3" fmla="*/ 59874 w 125027"/>
                  <a:gd name="connsiteY3" fmla="*/ 1216 h 166670"/>
                  <a:gd name="connsiteX4" fmla="*/ 62514 w 125027"/>
                  <a:gd name="connsiteY4" fmla="*/ 0 h 166670"/>
                  <a:gd name="connsiteX5" fmla="*/ 65153 w 125027"/>
                  <a:gd name="connsiteY5" fmla="*/ 1216 h 166670"/>
                  <a:gd name="connsiteX6" fmla="*/ 125027 w 125027"/>
                  <a:gd name="connsiteY6" fmla="*/ 105405 h 166670"/>
                  <a:gd name="connsiteX7" fmla="*/ 106440 w 125027"/>
                  <a:gd name="connsiteY7" fmla="*/ 148964 h 166670"/>
                  <a:gd name="connsiteX8" fmla="*/ 62514 w 125027"/>
                  <a:gd name="connsiteY8" fmla="*/ 166668 h 166670"/>
                  <a:gd name="connsiteX9" fmla="*/ 62514 w 125027"/>
                  <a:gd name="connsiteY9" fmla="*/ 8884 h 166670"/>
                  <a:gd name="connsiteX10" fmla="*/ 6946 w 125027"/>
                  <a:gd name="connsiteY10" fmla="*/ 105398 h 166670"/>
                  <a:gd name="connsiteX11" fmla="*/ 23509 w 125027"/>
                  <a:gd name="connsiteY11" fmla="*/ 144036 h 166670"/>
                  <a:gd name="connsiteX12" fmla="*/ 62514 w 125027"/>
                  <a:gd name="connsiteY12" fmla="*/ 159715 h 166670"/>
                  <a:gd name="connsiteX13" fmla="*/ 101518 w 125027"/>
                  <a:gd name="connsiteY13" fmla="*/ 144036 h 166670"/>
                  <a:gd name="connsiteX14" fmla="*/ 118081 w 125027"/>
                  <a:gd name="connsiteY14" fmla="*/ 105398 h 166670"/>
                  <a:gd name="connsiteX15" fmla="*/ 62514 w 125027"/>
                  <a:gd name="connsiteY15" fmla="*/ 8884 h 1666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25027" h="166670">
                    <a:moveTo>
                      <a:pt x="62514" y="166668"/>
                    </a:moveTo>
                    <a:cubicBezTo>
                      <a:pt x="46104" y="166817"/>
                      <a:pt x="30308" y="160449"/>
                      <a:pt x="18587" y="148964"/>
                    </a:cubicBezTo>
                    <a:cubicBezTo>
                      <a:pt x="6868" y="137479"/>
                      <a:pt x="183" y="121813"/>
                      <a:pt x="0" y="105405"/>
                    </a:cubicBezTo>
                    <a:cubicBezTo>
                      <a:pt x="0" y="72620"/>
                      <a:pt x="57408" y="4098"/>
                      <a:pt x="59874" y="1216"/>
                    </a:cubicBezTo>
                    <a:cubicBezTo>
                      <a:pt x="60534" y="445"/>
                      <a:pt x="61498" y="0"/>
                      <a:pt x="62514" y="0"/>
                    </a:cubicBezTo>
                    <a:cubicBezTo>
                      <a:pt x="63529" y="0"/>
                      <a:pt x="64493" y="445"/>
                      <a:pt x="65153" y="1216"/>
                    </a:cubicBezTo>
                    <a:cubicBezTo>
                      <a:pt x="67619" y="4098"/>
                      <a:pt x="125027" y="72620"/>
                      <a:pt x="125027" y="105405"/>
                    </a:cubicBezTo>
                    <a:cubicBezTo>
                      <a:pt x="124844" y="121813"/>
                      <a:pt x="118159" y="137479"/>
                      <a:pt x="106440" y="148964"/>
                    </a:cubicBezTo>
                    <a:cubicBezTo>
                      <a:pt x="94720" y="160450"/>
                      <a:pt x="78923" y="166817"/>
                      <a:pt x="62514" y="166668"/>
                    </a:cubicBezTo>
                    <a:close/>
                    <a:moveTo>
                      <a:pt x="62514" y="8884"/>
                    </a:moveTo>
                    <a:cubicBezTo>
                      <a:pt x="51122" y="22776"/>
                      <a:pt x="6946" y="78899"/>
                      <a:pt x="6946" y="105398"/>
                    </a:cubicBezTo>
                    <a:cubicBezTo>
                      <a:pt x="7138" y="119961"/>
                      <a:pt x="13094" y="133854"/>
                      <a:pt x="23509" y="144036"/>
                    </a:cubicBezTo>
                    <a:cubicBezTo>
                      <a:pt x="33924" y="154217"/>
                      <a:pt x="47949" y="159854"/>
                      <a:pt x="62514" y="159715"/>
                    </a:cubicBezTo>
                    <a:cubicBezTo>
                      <a:pt x="77078" y="159854"/>
                      <a:pt x="91103" y="154216"/>
                      <a:pt x="101518" y="144036"/>
                    </a:cubicBezTo>
                    <a:cubicBezTo>
                      <a:pt x="111933" y="133854"/>
                      <a:pt x="117889" y="119961"/>
                      <a:pt x="118081" y="105398"/>
                    </a:cubicBezTo>
                    <a:cubicBezTo>
                      <a:pt x="118081" y="78899"/>
                      <a:pt x="73905" y="22915"/>
                      <a:pt x="62514" y="8884"/>
                    </a:cubicBezTo>
                    <a:close/>
                  </a:path>
                </a:pathLst>
              </a:custGeom>
              <a:grpFill/>
              <a:ln w="138" cap="flat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35" name="Freeform: Shape 134">
                <a:extLst>
                  <a:ext uri="{FF2B5EF4-FFF2-40B4-BE49-F238E27FC236}">
                    <a16:creationId xmlns:a16="http://schemas.microsoft.com/office/drawing/2014/main" id="{EE11CA12-7C21-0DB4-EF95-C23F786E99EF}"/>
                  </a:ext>
                </a:extLst>
              </p:cNvPr>
              <p:cNvSpPr/>
              <p:nvPr/>
            </p:nvSpPr>
            <p:spPr>
              <a:xfrm>
                <a:off x="5732385" y="2428366"/>
                <a:ext cx="31235" cy="45877"/>
              </a:xfrm>
              <a:custGeom>
                <a:avLst/>
                <a:gdLst>
                  <a:gd name="connsiteX0" fmla="*/ 3452 w 31235"/>
                  <a:gd name="connsiteY0" fmla="*/ 45877 h 45877"/>
                  <a:gd name="connsiteX1" fmla="*/ 767 w 31235"/>
                  <a:gd name="connsiteY1" fmla="*/ 44581 h 45877"/>
                  <a:gd name="connsiteX2" fmla="*/ 76 w 31235"/>
                  <a:gd name="connsiteY2" fmla="*/ 41681 h 45877"/>
                  <a:gd name="connsiteX3" fmla="*/ 1889 w 31235"/>
                  <a:gd name="connsiteY3" fmla="*/ 39313 h 45877"/>
                  <a:gd name="connsiteX4" fmla="*/ 18178 w 31235"/>
                  <a:gd name="connsiteY4" fmla="*/ 24573 h 45877"/>
                  <a:gd name="connsiteX5" fmla="*/ 24290 w 31235"/>
                  <a:gd name="connsiteY5" fmla="*/ 3472 h 45877"/>
                  <a:gd name="connsiteX6" fmla="*/ 26026 w 31235"/>
                  <a:gd name="connsiteY6" fmla="*/ 465 h 45877"/>
                  <a:gd name="connsiteX7" fmla="*/ 29499 w 31235"/>
                  <a:gd name="connsiteY7" fmla="*/ 465 h 45877"/>
                  <a:gd name="connsiteX8" fmla="*/ 31236 w 31235"/>
                  <a:gd name="connsiteY8" fmla="*/ 3472 h 45877"/>
                  <a:gd name="connsiteX9" fmla="*/ 24097 w 31235"/>
                  <a:gd name="connsiteY9" fmla="*/ 28210 h 45877"/>
                  <a:gd name="connsiteX10" fmla="*/ 5015 w 31235"/>
                  <a:gd name="connsiteY10" fmla="*/ 45495 h 45877"/>
                  <a:gd name="connsiteX11" fmla="*/ 3452 w 31235"/>
                  <a:gd name="connsiteY11" fmla="*/ 45877 h 45877"/>
                  <a:gd name="connsiteX12" fmla="*/ 3452 w 31235"/>
                  <a:gd name="connsiteY12" fmla="*/ 45877 h 458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31235" h="45877">
                    <a:moveTo>
                      <a:pt x="3452" y="45877"/>
                    </a:moveTo>
                    <a:cubicBezTo>
                      <a:pt x="2408" y="45872"/>
                      <a:pt x="1421" y="45395"/>
                      <a:pt x="767" y="44581"/>
                    </a:cubicBezTo>
                    <a:cubicBezTo>
                      <a:pt x="113" y="43767"/>
                      <a:pt x="-142" y="42702"/>
                      <a:pt x="76" y="41681"/>
                    </a:cubicBezTo>
                    <a:cubicBezTo>
                      <a:pt x="295" y="40660"/>
                      <a:pt x="960" y="39790"/>
                      <a:pt x="1889" y="39313"/>
                    </a:cubicBezTo>
                    <a:cubicBezTo>
                      <a:pt x="8581" y="36007"/>
                      <a:pt x="14221" y="30903"/>
                      <a:pt x="18178" y="24573"/>
                    </a:cubicBezTo>
                    <a:cubicBezTo>
                      <a:pt x="22134" y="18242"/>
                      <a:pt x="24251" y="10936"/>
                      <a:pt x="24290" y="3472"/>
                    </a:cubicBezTo>
                    <a:cubicBezTo>
                      <a:pt x="24290" y="2232"/>
                      <a:pt x="24953" y="1086"/>
                      <a:pt x="26026" y="465"/>
                    </a:cubicBezTo>
                    <a:cubicBezTo>
                      <a:pt x="27100" y="-155"/>
                      <a:pt x="28426" y="-155"/>
                      <a:pt x="29499" y="465"/>
                    </a:cubicBezTo>
                    <a:cubicBezTo>
                      <a:pt x="30573" y="1086"/>
                      <a:pt x="31236" y="2232"/>
                      <a:pt x="31236" y="3472"/>
                    </a:cubicBezTo>
                    <a:cubicBezTo>
                      <a:pt x="31200" y="12221"/>
                      <a:pt x="28728" y="20787"/>
                      <a:pt x="24097" y="28210"/>
                    </a:cubicBezTo>
                    <a:cubicBezTo>
                      <a:pt x="19465" y="35632"/>
                      <a:pt x="12858" y="41618"/>
                      <a:pt x="5015" y="45495"/>
                    </a:cubicBezTo>
                    <a:cubicBezTo>
                      <a:pt x="4536" y="45755"/>
                      <a:pt x="3998" y="45887"/>
                      <a:pt x="3452" y="45877"/>
                    </a:cubicBezTo>
                    <a:lnTo>
                      <a:pt x="3452" y="45877"/>
                    </a:lnTo>
                    <a:close/>
                  </a:path>
                </a:pathLst>
              </a:custGeom>
              <a:grpFill/>
              <a:ln w="138" cap="flat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</p:grpSp>
      <p:sp>
        <p:nvSpPr>
          <p:cNvPr id="140" name="TextBox 139">
            <a:extLst>
              <a:ext uri="{FF2B5EF4-FFF2-40B4-BE49-F238E27FC236}">
                <a16:creationId xmlns:a16="http://schemas.microsoft.com/office/drawing/2014/main" id="{050F5DFB-06B9-C660-6DA2-C1389E7B82C1}"/>
              </a:ext>
            </a:extLst>
          </p:cNvPr>
          <p:cNvSpPr txBox="1"/>
          <p:nvPr/>
        </p:nvSpPr>
        <p:spPr>
          <a:xfrm>
            <a:off x="5876787" y="1994502"/>
            <a:ext cx="1415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chemeClr val="accent3">
                    <a:lumMod val="50000"/>
                  </a:schemeClr>
                </a:solidFill>
              </a:rPr>
              <a:t>Patients with more active than stable lesions: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96EB0F56-0C21-6A42-4AE1-B05717D84124}"/>
              </a:ext>
            </a:extLst>
          </p:cNvPr>
          <p:cNvGrpSpPr/>
          <p:nvPr/>
        </p:nvGrpSpPr>
        <p:grpSpPr>
          <a:xfrm>
            <a:off x="5845524" y="2280238"/>
            <a:ext cx="1633369" cy="228965"/>
            <a:chOff x="5845524" y="2056284"/>
            <a:chExt cx="1633369" cy="228965"/>
          </a:xfrm>
        </p:grpSpPr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90D9CE00-8489-18C1-17EC-F342330A77E5}"/>
                </a:ext>
              </a:extLst>
            </p:cNvPr>
            <p:cNvGrpSpPr/>
            <p:nvPr/>
          </p:nvGrpSpPr>
          <p:grpSpPr>
            <a:xfrm rot="10800000">
              <a:off x="5845524" y="2056284"/>
              <a:ext cx="122057" cy="204870"/>
              <a:chOff x="248576" y="2050744"/>
              <a:chExt cx="122057" cy="204870"/>
            </a:xfrm>
          </p:grpSpPr>
          <p:sp>
            <p:nvSpPr>
              <p:cNvPr id="159" name="Arrow: Pentagon 158">
                <a:extLst>
                  <a:ext uri="{FF2B5EF4-FFF2-40B4-BE49-F238E27FC236}">
                    <a16:creationId xmlns:a16="http://schemas.microsoft.com/office/drawing/2014/main" id="{DC5CB2DF-152D-B9E4-9A75-51F12876AB41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60" name="Graphic 159">
                <a:extLst>
                  <a:ext uri="{FF2B5EF4-FFF2-40B4-BE49-F238E27FC236}">
                    <a16:creationId xmlns:a16="http://schemas.microsoft.com/office/drawing/2014/main" id="{D676AA88-964A-818B-6F55-DF2EA38982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40666"/>
                <a:ext cx="101898" cy="122054"/>
              </a:xfrm>
              <a:prstGeom prst="rect">
                <a:avLst/>
              </a:prstGeom>
            </p:spPr>
          </p:pic>
        </p:grp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CD15C2E4-F522-F9A9-01CB-6ABCB75C7C78}"/>
                </a:ext>
              </a:extLst>
            </p:cNvPr>
            <p:cNvSpPr txBox="1"/>
            <p:nvPr/>
          </p:nvSpPr>
          <p:spPr>
            <a:xfrm>
              <a:off x="6030904" y="2131361"/>
              <a:ext cx="1447989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chemeClr val="accent2">
                      <a:lumMod val="50000"/>
                    </a:schemeClr>
                  </a:solidFill>
                </a:rPr>
                <a:t>NK cell signaling</a:t>
              </a:r>
            </a:p>
          </p:txBody>
        </p:sp>
      </p:grpSp>
      <p:sp>
        <p:nvSpPr>
          <p:cNvPr id="167" name="TextBox 166">
            <a:extLst>
              <a:ext uri="{FF2B5EF4-FFF2-40B4-BE49-F238E27FC236}">
                <a16:creationId xmlns:a16="http://schemas.microsoft.com/office/drawing/2014/main" id="{9308F390-05CF-C8C3-C705-99464F9B21E3}"/>
              </a:ext>
            </a:extLst>
          </p:cNvPr>
          <p:cNvSpPr txBox="1"/>
          <p:nvPr/>
        </p:nvSpPr>
        <p:spPr>
          <a:xfrm>
            <a:off x="6030905" y="2566145"/>
            <a:ext cx="1308414" cy="1384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900" dirty="0">
                <a:solidFill>
                  <a:schemeClr val="accent2">
                    <a:lumMod val="50000"/>
                  </a:schemeClr>
                </a:solidFill>
              </a:rPr>
              <a:t>Co-stimulatory molecules</a:t>
            </a:r>
          </a:p>
        </p:txBody>
      </p: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7131A1BB-B528-43EB-7AD2-0F21938A20EB}"/>
              </a:ext>
            </a:extLst>
          </p:cNvPr>
          <p:cNvGrpSpPr/>
          <p:nvPr/>
        </p:nvGrpSpPr>
        <p:grpSpPr>
          <a:xfrm rot="10800000">
            <a:off x="5845524" y="2494456"/>
            <a:ext cx="122057" cy="204870"/>
            <a:chOff x="248576" y="2050744"/>
            <a:chExt cx="122057" cy="204870"/>
          </a:xfrm>
        </p:grpSpPr>
        <p:sp>
          <p:nvSpPr>
            <p:cNvPr id="169" name="Arrow: Pentagon 168">
              <a:extLst>
                <a:ext uri="{FF2B5EF4-FFF2-40B4-BE49-F238E27FC236}">
                  <a16:creationId xmlns:a16="http://schemas.microsoft.com/office/drawing/2014/main" id="{E6B9B9C2-4FFA-2822-4E1C-2864C493499F}"/>
                </a:ext>
              </a:extLst>
            </p:cNvPr>
            <p:cNvSpPr/>
            <p:nvPr/>
          </p:nvSpPr>
          <p:spPr>
            <a:xfrm rot="16200000">
              <a:off x="223427" y="2108408"/>
              <a:ext cx="172358" cy="122054"/>
            </a:xfrm>
            <a:prstGeom prst="homePlate">
              <a:avLst/>
            </a:prstGeom>
            <a:gradFill>
              <a:gsLst>
                <a:gs pos="0">
                  <a:srgbClr val="F0EDF3">
                    <a:alpha val="0"/>
                  </a:srgbClr>
                </a:gs>
                <a:gs pos="100000">
                  <a:schemeClr val="accent2"/>
                </a:gs>
              </a:gsLst>
              <a:lin ang="21594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70" name="Graphic 169">
              <a:extLst>
                <a:ext uri="{FF2B5EF4-FFF2-40B4-BE49-F238E27FC236}">
                  <a16:creationId xmlns:a16="http://schemas.microsoft.com/office/drawing/2014/main" id="{3523A628-3A99-1063-7B39-0C1A85513C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5400000">
              <a:off x="258654" y="2040666"/>
              <a:ext cx="101898" cy="122054"/>
            </a:xfrm>
            <a:prstGeom prst="rect">
              <a:avLst/>
            </a:prstGeom>
          </p:spPr>
        </p:pic>
      </p:grpSp>
      <p:sp>
        <p:nvSpPr>
          <p:cNvPr id="204" name="Rectangle: Rounded Corners 203">
            <a:extLst>
              <a:ext uri="{FF2B5EF4-FFF2-40B4-BE49-F238E27FC236}">
                <a16:creationId xmlns:a16="http://schemas.microsoft.com/office/drawing/2014/main" id="{6C681065-0D38-A16E-AC8F-531EE15CC93B}"/>
              </a:ext>
            </a:extLst>
          </p:cNvPr>
          <p:cNvSpPr/>
          <p:nvPr/>
        </p:nvSpPr>
        <p:spPr>
          <a:xfrm>
            <a:off x="4068723" y="1845084"/>
            <a:ext cx="1554480" cy="1188720"/>
          </a:xfrm>
          <a:prstGeom prst="roundRect">
            <a:avLst>
              <a:gd name="adj" fmla="val 9307"/>
            </a:avLst>
          </a:prstGeom>
          <a:noFill/>
          <a:ln>
            <a:solidFill>
              <a:srgbClr val="66AF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86945AD5-82E3-8550-FB3D-B00A866BF759}"/>
              </a:ext>
            </a:extLst>
          </p:cNvPr>
          <p:cNvGrpSpPr/>
          <p:nvPr/>
        </p:nvGrpSpPr>
        <p:grpSpPr>
          <a:xfrm>
            <a:off x="4525234" y="1759830"/>
            <a:ext cx="270769" cy="270769"/>
            <a:chOff x="2472431" y="2428043"/>
            <a:chExt cx="270769" cy="270769"/>
          </a:xfrm>
        </p:grpSpPr>
        <p:sp>
          <p:nvSpPr>
            <p:cNvPr id="137" name="Oval 136">
              <a:extLst>
                <a:ext uri="{FF2B5EF4-FFF2-40B4-BE49-F238E27FC236}">
                  <a16:creationId xmlns:a16="http://schemas.microsoft.com/office/drawing/2014/main" id="{4546390B-CB9C-89D8-3D21-EBF35A892FAF}"/>
                </a:ext>
              </a:extLst>
            </p:cNvPr>
            <p:cNvSpPr/>
            <p:nvPr/>
          </p:nvSpPr>
          <p:spPr>
            <a:xfrm>
              <a:off x="2472431" y="2428043"/>
              <a:ext cx="270769" cy="270769"/>
            </a:xfrm>
            <a:prstGeom prst="ellips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Graphic 22">
              <a:extLst>
                <a:ext uri="{FF2B5EF4-FFF2-40B4-BE49-F238E27FC236}">
                  <a16:creationId xmlns:a16="http://schemas.microsoft.com/office/drawing/2014/main" id="{727838FC-AC51-1BE1-990C-6FD4B3A6DA46}"/>
                </a:ext>
              </a:extLst>
            </p:cNvPr>
            <p:cNvSpPr/>
            <p:nvPr/>
          </p:nvSpPr>
          <p:spPr>
            <a:xfrm>
              <a:off x="2500641" y="2487111"/>
              <a:ext cx="214349" cy="152633"/>
            </a:xfrm>
            <a:custGeom>
              <a:avLst/>
              <a:gdLst>
                <a:gd name="connsiteX0" fmla="*/ 239656 w 242427"/>
                <a:gd name="connsiteY0" fmla="*/ 33943 h 172627"/>
                <a:gd name="connsiteX1" fmla="*/ 239364 w 242427"/>
                <a:gd name="connsiteY1" fmla="*/ 33652 h 172627"/>
                <a:gd name="connsiteX2" fmla="*/ 238490 w 242427"/>
                <a:gd name="connsiteY2" fmla="*/ 33069 h 172627"/>
                <a:gd name="connsiteX3" fmla="*/ 238782 w 242427"/>
                <a:gd name="connsiteY3" fmla="*/ 32777 h 172627"/>
                <a:gd name="connsiteX4" fmla="*/ 238782 w 242427"/>
                <a:gd name="connsiteY4" fmla="*/ 18210 h 172627"/>
                <a:gd name="connsiteX5" fmla="*/ 238490 w 242427"/>
                <a:gd name="connsiteY5" fmla="*/ 17918 h 172627"/>
                <a:gd name="connsiteX6" fmla="*/ 237033 w 242427"/>
                <a:gd name="connsiteY6" fmla="*/ 16753 h 172627"/>
                <a:gd name="connsiteX7" fmla="*/ 234703 w 242427"/>
                <a:gd name="connsiteY7" fmla="*/ 5681 h 172627"/>
                <a:gd name="connsiteX8" fmla="*/ 234411 w 242427"/>
                <a:gd name="connsiteY8" fmla="*/ 5390 h 172627"/>
                <a:gd name="connsiteX9" fmla="*/ 221009 w 242427"/>
                <a:gd name="connsiteY9" fmla="*/ 4225 h 172627"/>
                <a:gd name="connsiteX10" fmla="*/ 220135 w 242427"/>
                <a:gd name="connsiteY10" fmla="*/ 3351 h 172627"/>
                <a:gd name="connsiteX11" fmla="*/ 219843 w 242427"/>
                <a:gd name="connsiteY11" fmla="*/ 3059 h 172627"/>
                <a:gd name="connsiteX12" fmla="*/ 205276 w 242427"/>
                <a:gd name="connsiteY12" fmla="*/ 3059 h 172627"/>
                <a:gd name="connsiteX13" fmla="*/ 182550 w 242427"/>
                <a:gd name="connsiteY13" fmla="*/ 24620 h 172627"/>
                <a:gd name="connsiteX14" fmla="*/ 182258 w 242427"/>
                <a:gd name="connsiteY14" fmla="*/ 24911 h 172627"/>
                <a:gd name="connsiteX15" fmla="*/ 183715 w 242427"/>
                <a:gd name="connsiteY15" fmla="*/ 14422 h 172627"/>
                <a:gd name="connsiteX16" fmla="*/ 175849 w 242427"/>
                <a:gd name="connsiteY16" fmla="*/ 2185 h 172627"/>
                <a:gd name="connsiteX17" fmla="*/ 175557 w 242427"/>
                <a:gd name="connsiteY17" fmla="*/ 2185 h 172627"/>
                <a:gd name="connsiteX18" fmla="*/ 163320 w 242427"/>
                <a:gd name="connsiteY18" fmla="*/ 10052 h 172627"/>
                <a:gd name="connsiteX19" fmla="*/ 156328 w 242427"/>
                <a:gd name="connsiteY19" fmla="*/ 36565 h 172627"/>
                <a:gd name="connsiteX20" fmla="*/ 147004 w 242427"/>
                <a:gd name="connsiteY20" fmla="*/ 72110 h 172627"/>
                <a:gd name="connsiteX21" fmla="*/ 103592 w 242427"/>
                <a:gd name="connsiteY21" fmla="*/ 103577 h 172627"/>
                <a:gd name="connsiteX22" fmla="*/ 47652 w 242427"/>
                <a:gd name="connsiteY22" fmla="*/ 46471 h 172627"/>
                <a:gd name="connsiteX23" fmla="*/ 40660 w 242427"/>
                <a:gd name="connsiteY23" fmla="*/ 45306 h 172627"/>
                <a:gd name="connsiteX24" fmla="*/ 39785 w 242427"/>
                <a:gd name="connsiteY24" fmla="*/ 51716 h 172627"/>
                <a:gd name="connsiteX25" fmla="*/ 99513 w 242427"/>
                <a:gd name="connsiteY25" fmla="*/ 112317 h 172627"/>
                <a:gd name="connsiteX26" fmla="*/ 105049 w 242427"/>
                <a:gd name="connsiteY26" fmla="*/ 112609 h 172627"/>
                <a:gd name="connsiteX27" fmla="*/ 154580 w 242427"/>
                <a:gd name="connsiteY27" fmla="*/ 76772 h 172627"/>
                <a:gd name="connsiteX28" fmla="*/ 155745 w 242427"/>
                <a:gd name="connsiteY28" fmla="*/ 71819 h 172627"/>
                <a:gd name="connsiteX29" fmla="*/ 163029 w 242427"/>
                <a:gd name="connsiteY29" fmla="*/ 41809 h 172627"/>
                <a:gd name="connsiteX30" fmla="*/ 164194 w 242427"/>
                <a:gd name="connsiteY30" fmla="*/ 39770 h 172627"/>
                <a:gd name="connsiteX31" fmla="*/ 171478 w 242427"/>
                <a:gd name="connsiteY31" fmla="*/ 12091 h 172627"/>
                <a:gd name="connsiteX32" fmla="*/ 172644 w 242427"/>
                <a:gd name="connsiteY32" fmla="*/ 11217 h 172627"/>
                <a:gd name="connsiteX33" fmla="*/ 172935 w 242427"/>
                <a:gd name="connsiteY33" fmla="*/ 11217 h 172627"/>
                <a:gd name="connsiteX34" fmla="*/ 173809 w 242427"/>
                <a:gd name="connsiteY34" fmla="*/ 12383 h 172627"/>
                <a:gd name="connsiteX35" fmla="*/ 173809 w 242427"/>
                <a:gd name="connsiteY35" fmla="*/ 12674 h 172627"/>
                <a:gd name="connsiteX36" fmla="*/ 171187 w 242427"/>
                <a:gd name="connsiteY36" fmla="*/ 33360 h 172627"/>
                <a:gd name="connsiteX37" fmla="*/ 173809 w 242427"/>
                <a:gd name="connsiteY37" fmla="*/ 38313 h 172627"/>
                <a:gd name="connsiteX38" fmla="*/ 178762 w 242427"/>
                <a:gd name="connsiteY38" fmla="*/ 38313 h 172627"/>
                <a:gd name="connsiteX39" fmla="*/ 188086 w 242427"/>
                <a:gd name="connsiteY39" fmla="*/ 32195 h 172627"/>
                <a:gd name="connsiteX40" fmla="*/ 188960 w 242427"/>
                <a:gd name="connsiteY40" fmla="*/ 31612 h 172627"/>
                <a:gd name="connsiteX41" fmla="*/ 211394 w 242427"/>
                <a:gd name="connsiteY41" fmla="*/ 8886 h 172627"/>
                <a:gd name="connsiteX42" fmla="*/ 212851 w 242427"/>
                <a:gd name="connsiteY42" fmla="*/ 8886 h 172627"/>
                <a:gd name="connsiteX43" fmla="*/ 213142 w 242427"/>
                <a:gd name="connsiteY43" fmla="*/ 9178 h 172627"/>
                <a:gd name="connsiteX44" fmla="*/ 213142 w 242427"/>
                <a:gd name="connsiteY44" fmla="*/ 10634 h 172627"/>
                <a:gd name="connsiteX45" fmla="*/ 190416 w 242427"/>
                <a:gd name="connsiteY45" fmla="*/ 33360 h 172627"/>
                <a:gd name="connsiteX46" fmla="*/ 190416 w 242427"/>
                <a:gd name="connsiteY46" fmla="*/ 40061 h 172627"/>
                <a:gd name="connsiteX47" fmla="*/ 193621 w 242427"/>
                <a:gd name="connsiteY47" fmla="*/ 41518 h 172627"/>
                <a:gd name="connsiteX48" fmla="*/ 196826 w 242427"/>
                <a:gd name="connsiteY48" fmla="*/ 40061 h 172627"/>
                <a:gd name="connsiteX49" fmla="*/ 225671 w 242427"/>
                <a:gd name="connsiteY49" fmla="*/ 11509 h 172627"/>
                <a:gd name="connsiteX50" fmla="*/ 227127 w 242427"/>
                <a:gd name="connsiteY50" fmla="*/ 11509 h 172627"/>
                <a:gd name="connsiteX51" fmla="*/ 227419 w 242427"/>
                <a:gd name="connsiteY51" fmla="*/ 11800 h 172627"/>
                <a:gd name="connsiteX52" fmla="*/ 227419 w 242427"/>
                <a:gd name="connsiteY52" fmla="*/ 13257 h 172627"/>
                <a:gd name="connsiteX53" fmla="*/ 198283 w 242427"/>
                <a:gd name="connsiteY53" fmla="*/ 42392 h 172627"/>
                <a:gd name="connsiteX54" fmla="*/ 198283 w 242427"/>
                <a:gd name="connsiteY54" fmla="*/ 49093 h 172627"/>
                <a:gd name="connsiteX55" fmla="*/ 204984 w 242427"/>
                <a:gd name="connsiteY55" fmla="*/ 49093 h 172627"/>
                <a:gd name="connsiteX56" fmla="*/ 229750 w 242427"/>
                <a:gd name="connsiteY56" fmla="*/ 24328 h 172627"/>
                <a:gd name="connsiteX57" fmla="*/ 231206 w 242427"/>
                <a:gd name="connsiteY57" fmla="*/ 24328 h 172627"/>
                <a:gd name="connsiteX58" fmla="*/ 231498 w 242427"/>
                <a:gd name="connsiteY58" fmla="*/ 24620 h 172627"/>
                <a:gd name="connsiteX59" fmla="*/ 231498 w 242427"/>
                <a:gd name="connsiteY59" fmla="*/ 26076 h 172627"/>
                <a:gd name="connsiteX60" fmla="*/ 206441 w 242427"/>
                <a:gd name="connsiteY60" fmla="*/ 51424 h 172627"/>
                <a:gd name="connsiteX61" fmla="*/ 206441 w 242427"/>
                <a:gd name="connsiteY61" fmla="*/ 58125 h 172627"/>
                <a:gd name="connsiteX62" fmla="*/ 213142 w 242427"/>
                <a:gd name="connsiteY62" fmla="*/ 58125 h 172627"/>
                <a:gd name="connsiteX63" fmla="*/ 230915 w 242427"/>
                <a:gd name="connsiteY63" fmla="*/ 40353 h 172627"/>
                <a:gd name="connsiteX64" fmla="*/ 232372 w 242427"/>
                <a:gd name="connsiteY64" fmla="*/ 40353 h 172627"/>
                <a:gd name="connsiteX65" fmla="*/ 232663 w 242427"/>
                <a:gd name="connsiteY65" fmla="*/ 40644 h 172627"/>
                <a:gd name="connsiteX66" fmla="*/ 232663 w 242427"/>
                <a:gd name="connsiteY66" fmla="*/ 42101 h 172627"/>
                <a:gd name="connsiteX67" fmla="*/ 213725 w 242427"/>
                <a:gd name="connsiteY67" fmla="*/ 61039 h 172627"/>
                <a:gd name="connsiteX68" fmla="*/ 191873 w 242427"/>
                <a:gd name="connsiteY68" fmla="*/ 80851 h 172627"/>
                <a:gd name="connsiteX69" fmla="*/ 177888 w 242427"/>
                <a:gd name="connsiteY69" fmla="*/ 86678 h 172627"/>
                <a:gd name="connsiteX70" fmla="*/ 173809 w 242427"/>
                <a:gd name="connsiteY70" fmla="*/ 88135 h 172627"/>
                <a:gd name="connsiteX71" fmla="*/ 148170 w 242427"/>
                <a:gd name="connsiteY71" fmla="*/ 117853 h 172627"/>
                <a:gd name="connsiteX72" fmla="*/ 107963 w 242427"/>
                <a:gd name="connsiteY72" fmla="*/ 156312 h 172627"/>
                <a:gd name="connsiteX73" fmla="*/ 104466 w 242427"/>
                <a:gd name="connsiteY73" fmla="*/ 159226 h 172627"/>
                <a:gd name="connsiteX74" fmla="*/ 97474 w 242427"/>
                <a:gd name="connsiteY74" fmla="*/ 163305 h 172627"/>
                <a:gd name="connsiteX75" fmla="*/ 90481 w 242427"/>
                <a:gd name="connsiteY75" fmla="*/ 159226 h 172627"/>
                <a:gd name="connsiteX76" fmla="*/ 7736 w 242427"/>
                <a:gd name="connsiteY76" fmla="*/ 91340 h 172627"/>
                <a:gd name="connsiteX77" fmla="*/ 1035 w 242427"/>
                <a:gd name="connsiteY77" fmla="*/ 91923 h 172627"/>
                <a:gd name="connsiteX78" fmla="*/ 1909 w 242427"/>
                <a:gd name="connsiteY78" fmla="*/ 98915 h 172627"/>
                <a:gd name="connsiteX79" fmla="*/ 84946 w 242427"/>
                <a:gd name="connsiteY79" fmla="*/ 166801 h 172627"/>
                <a:gd name="connsiteX80" fmla="*/ 97474 w 242427"/>
                <a:gd name="connsiteY80" fmla="*/ 172628 h 172627"/>
                <a:gd name="connsiteX81" fmla="*/ 98057 w 242427"/>
                <a:gd name="connsiteY81" fmla="*/ 172628 h 172627"/>
                <a:gd name="connsiteX82" fmla="*/ 110585 w 242427"/>
                <a:gd name="connsiteY82" fmla="*/ 166218 h 172627"/>
                <a:gd name="connsiteX83" fmla="*/ 113498 w 242427"/>
                <a:gd name="connsiteY83" fmla="*/ 163887 h 172627"/>
                <a:gd name="connsiteX84" fmla="*/ 155454 w 242427"/>
                <a:gd name="connsiteY84" fmla="*/ 123680 h 172627"/>
                <a:gd name="connsiteX85" fmla="*/ 179345 w 242427"/>
                <a:gd name="connsiteY85" fmla="*/ 96002 h 172627"/>
                <a:gd name="connsiteX86" fmla="*/ 198283 w 242427"/>
                <a:gd name="connsiteY86" fmla="*/ 87552 h 172627"/>
                <a:gd name="connsiteX87" fmla="*/ 219843 w 242427"/>
                <a:gd name="connsiteY87" fmla="*/ 68031 h 172627"/>
                <a:gd name="connsiteX88" fmla="*/ 220135 w 242427"/>
                <a:gd name="connsiteY88" fmla="*/ 67740 h 172627"/>
                <a:gd name="connsiteX89" fmla="*/ 239073 w 242427"/>
                <a:gd name="connsiteY89" fmla="*/ 48511 h 172627"/>
                <a:gd name="connsiteX90" fmla="*/ 239656 w 242427"/>
                <a:gd name="connsiteY90" fmla="*/ 33943 h 172627"/>
                <a:gd name="connsiteX91" fmla="*/ 239656 w 242427"/>
                <a:gd name="connsiteY91" fmla="*/ 33943 h 1726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</a:cxnLst>
              <a:rect l="l" t="t" r="r" b="b"/>
              <a:pathLst>
                <a:path w="242427" h="172627">
                  <a:moveTo>
                    <a:pt x="239656" y="33943"/>
                  </a:moveTo>
                  <a:lnTo>
                    <a:pt x="239364" y="33652"/>
                  </a:lnTo>
                  <a:cubicBezTo>
                    <a:pt x="239073" y="33360"/>
                    <a:pt x="238782" y="33069"/>
                    <a:pt x="238490" y="33069"/>
                  </a:cubicBezTo>
                  <a:lnTo>
                    <a:pt x="238782" y="32777"/>
                  </a:lnTo>
                  <a:cubicBezTo>
                    <a:pt x="242861" y="28698"/>
                    <a:pt x="242861" y="21997"/>
                    <a:pt x="238782" y="18210"/>
                  </a:cubicBezTo>
                  <a:lnTo>
                    <a:pt x="238490" y="17918"/>
                  </a:lnTo>
                  <a:cubicBezTo>
                    <a:pt x="237907" y="17336"/>
                    <a:pt x="237616" y="17044"/>
                    <a:pt x="237033" y="16753"/>
                  </a:cubicBezTo>
                  <a:cubicBezTo>
                    <a:pt x="238490" y="12965"/>
                    <a:pt x="237616" y="8595"/>
                    <a:pt x="234703" y="5681"/>
                  </a:cubicBezTo>
                  <a:lnTo>
                    <a:pt x="234411" y="5390"/>
                  </a:lnTo>
                  <a:cubicBezTo>
                    <a:pt x="230915" y="1894"/>
                    <a:pt x="225088" y="1311"/>
                    <a:pt x="221009" y="4225"/>
                  </a:cubicBezTo>
                  <a:cubicBezTo>
                    <a:pt x="220717" y="3933"/>
                    <a:pt x="220426" y="3642"/>
                    <a:pt x="220135" y="3351"/>
                  </a:cubicBezTo>
                  <a:lnTo>
                    <a:pt x="219843" y="3059"/>
                  </a:lnTo>
                  <a:cubicBezTo>
                    <a:pt x="215764" y="-1020"/>
                    <a:pt x="209063" y="-1020"/>
                    <a:pt x="205276" y="3059"/>
                  </a:cubicBezTo>
                  <a:lnTo>
                    <a:pt x="182550" y="24620"/>
                  </a:lnTo>
                  <a:lnTo>
                    <a:pt x="182258" y="24911"/>
                  </a:lnTo>
                  <a:lnTo>
                    <a:pt x="183715" y="14422"/>
                  </a:lnTo>
                  <a:cubicBezTo>
                    <a:pt x="184881" y="8886"/>
                    <a:pt x="181384" y="3351"/>
                    <a:pt x="175849" y="2185"/>
                  </a:cubicBezTo>
                  <a:lnTo>
                    <a:pt x="175557" y="2185"/>
                  </a:lnTo>
                  <a:cubicBezTo>
                    <a:pt x="170022" y="1020"/>
                    <a:pt x="164486" y="4516"/>
                    <a:pt x="163320" y="10052"/>
                  </a:cubicBezTo>
                  <a:lnTo>
                    <a:pt x="156328" y="36565"/>
                  </a:lnTo>
                  <a:cubicBezTo>
                    <a:pt x="143800" y="50259"/>
                    <a:pt x="145548" y="65409"/>
                    <a:pt x="147004" y="72110"/>
                  </a:cubicBezTo>
                  <a:cubicBezTo>
                    <a:pt x="142051" y="76189"/>
                    <a:pt x="128649" y="86678"/>
                    <a:pt x="103592" y="103577"/>
                  </a:cubicBezTo>
                  <a:cubicBezTo>
                    <a:pt x="94852" y="95710"/>
                    <a:pt x="65716" y="69488"/>
                    <a:pt x="47652" y="46471"/>
                  </a:cubicBezTo>
                  <a:cubicBezTo>
                    <a:pt x="45613" y="44140"/>
                    <a:pt x="42699" y="43849"/>
                    <a:pt x="40660" y="45306"/>
                  </a:cubicBezTo>
                  <a:cubicBezTo>
                    <a:pt x="38620" y="46763"/>
                    <a:pt x="38329" y="49967"/>
                    <a:pt x="39785" y="51716"/>
                  </a:cubicBezTo>
                  <a:cubicBezTo>
                    <a:pt x="61637" y="79686"/>
                    <a:pt x="98057" y="111152"/>
                    <a:pt x="99513" y="112317"/>
                  </a:cubicBezTo>
                  <a:cubicBezTo>
                    <a:pt x="100970" y="113774"/>
                    <a:pt x="103301" y="113774"/>
                    <a:pt x="105049" y="112609"/>
                  </a:cubicBezTo>
                  <a:cubicBezTo>
                    <a:pt x="140303" y="89009"/>
                    <a:pt x="153997" y="77063"/>
                    <a:pt x="154580" y="76772"/>
                  </a:cubicBezTo>
                  <a:cubicBezTo>
                    <a:pt x="156036" y="75607"/>
                    <a:pt x="156619" y="73567"/>
                    <a:pt x="155745" y="71819"/>
                  </a:cubicBezTo>
                  <a:cubicBezTo>
                    <a:pt x="155454" y="71236"/>
                    <a:pt x="149918" y="55212"/>
                    <a:pt x="163029" y="41809"/>
                  </a:cubicBezTo>
                  <a:cubicBezTo>
                    <a:pt x="163612" y="41227"/>
                    <a:pt x="163903" y="40644"/>
                    <a:pt x="164194" y="39770"/>
                  </a:cubicBezTo>
                  <a:lnTo>
                    <a:pt x="171478" y="12091"/>
                  </a:lnTo>
                  <a:cubicBezTo>
                    <a:pt x="171478" y="11509"/>
                    <a:pt x="172061" y="11217"/>
                    <a:pt x="172644" y="11217"/>
                  </a:cubicBezTo>
                  <a:lnTo>
                    <a:pt x="172935" y="11217"/>
                  </a:lnTo>
                  <a:cubicBezTo>
                    <a:pt x="173518" y="11217"/>
                    <a:pt x="173809" y="11800"/>
                    <a:pt x="173809" y="12383"/>
                  </a:cubicBezTo>
                  <a:lnTo>
                    <a:pt x="173809" y="12674"/>
                  </a:lnTo>
                  <a:lnTo>
                    <a:pt x="171187" y="33360"/>
                  </a:lnTo>
                  <a:cubicBezTo>
                    <a:pt x="171478" y="35400"/>
                    <a:pt x="172061" y="37148"/>
                    <a:pt x="173809" y="38313"/>
                  </a:cubicBezTo>
                  <a:cubicBezTo>
                    <a:pt x="175266" y="39187"/>
                    <a:pt x="177305" y="39187"/>
                    <a:pt x="178762" y="38313"/>
                  </a:cubicBezTo>
                  <a:lnTo>
                    <a:pt x="188086" y="32195"/>
                  </a:lnTo>
                  <a:cubicBezTo>
                    <a:pt x="188377" y="31903"/>
                    <a:pt x="188668" y="31903"/>
                    <a:pt x="188960" y="31612"/>
                  </a:cubicBezTo>
                  <a:lnTo>
                    <a:pt x="211394" y="8886"/>
                  </a:lnTo>
                  <a:cubicBezTo>
                    <a:pt x="211685" y="8595"/>
                    <a:pt x="212559" y="8595"/>
                    <a:pt x="212851" y="8886"/>
                  </a:cubicBezTo>
                  <a:lnTo>
                    <a:pt x="213142" y="9178"/>
                  </a:lnTo>
                  <a:cubicBezTo>
                    <a:pt x="213434" y="9469"/>
                    <a:pt x="213434" y="10052"/>
                    <a:pt x="213142" y="10634"/>
                  </a:cubicBezTo>
                  <a:lnTo>
                    <a:pt x="190416" y="33360"/>
                  </a:lnTo>
                  <a:cubicBezTo>
                    <a:pt x="188668" y="35108"/>
                    <a:pt x="188668" y="38022"/>
                    <a:pt x="190416" y="40061"/>
                  </a:cubicBezTo>
                  <a:cubicBezTo>
                    <a:pt x="191291" y="40935"/>
                    <a:pt x="192456" y="41518"/>
                    <a:pt x="193621" y="41518"/>
                  </a:cubicBezTo>
                  <a:cubicBezTo>
                    <a:pt x="194787" y="41518"/>
                    <a:pt x="195952" y="40935"/>
                    <a:pt x="196826" y="40061"/>
                  </a:cubicBezTo>
                  <a:lnTo>
                    <a:pt x="225671" y="11509"/>
                  </a:lnTo>
                  <a:cubicBezTo>
                    <a:pt x="225962" y="11217"/>
                    <a:pt x="226836" y="11217"/>
                    <a:pt x="227127" y="11509"/>
                  </a:cubicBezTo>
                  <a:lnTo>
                    <a:pt x="227419" y="11800"/>
                  </a:lnTo>
                  <a:cubicBezTo>
                    <a:pt x="227710" y="12091"/>
                    <a:pt x="227710" y="12965"/>
                    <a:pt x="227419" y="13257"/>
                  </a:cubicBezTo>
                  <a:lnTo>
                    <a:pt x="198283" y="42392"/>
                  </a:lnTo>
                  <a:cubicBezTo>
                    <a:pt x="196535" y="44140"/>
                    <a:pt x="196535" y="47054"/>
                    <a:pt x="198283" y="49093"/>
                  </a:cubicBezTo>
                  <a:cubicBezTo>
                    <a:pt x="200031" y="50841"/>
                    <a:pt x="202945" y="50841"/>
                    <a:pt x="204984" y="49093"/>
                  </a:cubicBezTo>
                  <a:lnTo>
                    <a:pt x="229750" y="24328"/>
                  </a:lnTo>
                  <a:cubicBezTo>
                    <a:pt x="230041" y="24037"/>
                    <a:pt x="230915" y="24037"/>
                    <a:pt x="231206" y="24328"/>
                  </a:cubicBezTo>
                  <a:lnTo>
                    <a:pt x="231498" y="24620"/>
                  </a:lnTo>
                  <a:cubicBezTo>
                    <a:pt x="231789" y="24911"/>
                    <a:pt x="231789" y="25785"/>
                    <a:pt x="231498" y="26076"/>
                  </a:cubicBezTo>
                  <a:lnTo>
                    <a:pt x="206441" y="51424"/>
                  </a:lnTo>
                  <a:cubicBezTo>
                    <a:pt x="204693" y="53172"/>
                    <a:pt x="204693" y="56086"/>
                    <a:pt x="206441" y="58125"/>
                  </a:cubicBezTo>
                  <a:cubicBezTo>
                    <a:pt x="208189" y="59874"/>
                    <a:pt x="211103" y="59874"/>
                    <a:pt x="213142" y="58125"/>
                  </a:cubicBezTo>
                  <a:lnTo>
                    <a:pt x="230915" y="40353"/>
                  </a:lnTo>
                  <a:cubicBezTo>
                    <a:pt x="231206" y="40061"/>
                    <a:pt x="232080" y="40061"/>
                    <a:pt x="232372" y="40353"/>
                  </a:cubicBezTo>
                  <a:lnTo>
                    <a:pt x="232663" y="40644"/>
                  </a:lnTo>
                  <a:cubicBezTo>
                    <a:pt x="232954" y="40935"/>
                    <a:pt x="232954" y="41809"/>
                    <a:pt x="232663" y="42101"/>
                  </a:cubicBezTo>
                  <a:lnTo>
                    <a:pt x="213725" y="61039"/>
                  </a:lnTo>
                  <a:lnTo>
                    <a:pt x="191873" y="80851"/>
                  </a:lnTo>
                  <a:cubicBezTo>
                    <a:pt x="189834" y="82599"/>
                    <a:pt x="183424" y="87552"/>
                    <a:pt x="177888" y="86678"/>
                  </a:cubicBezTo>
                  <a:cubicBezTo>
                    <a:pt x="176431" y="86387"/>
                    <a:pt x="174683" y="86970"/>
                    <a:pt x="173809" y="88135"/>
                  </a:cubicBezTo>
                  <a:cubicBezTo>
                    <a:pt x="162446" y="100663"/>
                    <a:pt x="154580" y="110278"/>
                    <a:pt x="148170" y="117853"/>
                  </a:cubicBezTo>
                  <a:cubicBezTo>
                    <a:pt x="134476" y="134169"/>
                    <a:pt x="127484" y="142618"/>
                    <a:pt x="107963" y="156312"/>
                  </a:cubicBezTo>
                  <a:cubicBezTo>
                    <a:pt x="106797" y="157186"/>
                    <a:pt x="105632" y="158060"/>
                    <a:pt x="104466" y="159226"/>
                  </a:cubicBezTo>
                  <a:cubicBezTo>
                    <a:pt x="102136" y="161265"/>
                    <a:pt x="99805" y="163305"/>
                    <a:pt x="97474" y="163305"/>
                  </a:cubicBezTo>
                  <a:cubicBezTo>
                    <a:pt x="95434" y="163305"/>
                    <a:pt x="92812" y="161265"/>
                    <a:pt x="90481" y="159226"/>
                  </a:cubicBezTo>
                  <a:cubicBezTo>
                    <a:pt x="82032" y="152524"/>
                    <a:pt x="8610" y="92214"/>
                    <a:pt x="7736" y="91340"/>
                  </a:cubicBezTo>
                  <a:cubicBezTo>
                    <a:pt x="5697" y="89592"/>
                    <a:pt x="2783" y="89883"/>
                    <a:pt x="1035" y="91923"/>
                  </a:cubicBezTo>
                  <a:cubicBezTo>
                    <a:pt x="-713" y="93962"/>
                    <a:pt x="-130" y="97458"/>
                    <a:pt x="1909" y="98915"/>
                  </a:cubicBezTo>
                  <a:cubicBezTo>
                    <a:pt x="2783" y="99498"/>
                    <a:pt x="76205" y="160100"/>
                    <a:pt x="84946" y="166801"/>
                  </a:cubicBezTo>
                  <a:cubicBezTo>
                    <a:pt x="88151" y="169423"/>
                    <a:pt x="92230" y="172628"/>
                    <a:pt x="97474" y="172628"/>
                  </a:cubicBezTo>
                  <a:lnTo>
                    <a:pt x="98057" y="172628"/>
                  </a:lnTo>
                  <a:cubicBezTo>
                    <a:pt x="103301" y="172337"/>
                    <a:pt x="107380" y="168840"/>
                    <a:pt x="110585" y="166218"/>
                  </a:cubicBezTo>
                  <a:cubicBezTo>
                    <a:pt x="111459" y="165344"/>
                    <a:pt x="112624" y="164470"/>
                    <a:pt x="113498" y="163887"/>
                  </a:cubicBezTo>
                  <a:cubicBezTo>
                    <a:pt x="133893" y="149320"/>
                    <a:pt x="141760" y="140288"/>
                    <a:pt x="155454" y="123680"/>
                  </a:cubicBezTo>
                  <a:cubicBezTo>
                    <a:pt x="161572" y="116396"/>
                    <a:pt x="169147" y="107656"/>
                    <a:pt x="179345" y="96002"/>
                  </a:cubicBezTo>
                  <a:cubicBezTo>
                    <a:pt x="188960" y="96002"/>
                    <a:pt x="197409" y="88426"/>
                    <a:pt x="198283" y="87552"/>
                  </a:cubicBezTo>
                  <a:lnTo>
                    <a:pt x="219843" y="68031"/>
                  </a:lnTo>
                  <a:cubicBezTo>
                    <a:pt x="220135" y="68031"/>
                    <a:pt x="220135" y="67740"/>
                    <a:pt x="220135" y="67740"/>
                  </a:cubicBezTo>
                  <a:lnTo>
                    <a:pt x="239073" y="48511"/>
                  </a:lnTo>
                  <a:cubicBezTo>
                    <a:pt x="243443" y="44723"/>
                    <a:pt x="243443" y="38022"/>
                    <a:pt x="239656" y="33943"/>
                  </a:cubicBezTo>
                  <a:lnTo>
                    <a:pt x="239656" y="33943"/>
                  </a:lnTo>
                  <a:close/>
                </a:path>
              </a:pathLst>
            </a:custGeom>
            <a:solidFill>
              <a:schemeClr val="bg1"/>
            </a:solidFill>
            <a:ln w="239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139" name="TextBox 138">
            <a:extLst>
              <a:ext uri="{FF2B5EF4-FFF2-40B4-BE49-F238E27FC236}">
                <a16:creationId xmlns:a16="http://schemas.microsoft.com/office/drawing/2014/main" id="{02D99648-CBD1-6A32-C1C9-4B51D9582B19}"/>
              </a:ext>
            </a:extLst>
          </p:cNvPr>
          <p:cNvSpPr txBox="1"/>
          <p:nvPr/>
        </p:nvSpPr>
        <p:spPr>
          <a:xfrm>
            <a:off x="4304943" y="2025950"/>
            <a:ext cx="1173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accent4">
                    <a:lumMod val="50000"/>
                  </a:schemeClr>
                </a:solidFill>
              </a:rPr>
              <a:t>Stable lesions:</a:t>
            </a:r>
          </a:p>
        </p:txBody>
      </p: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80C1CDA0-1256-612A-BB35-5B8E5E081C97}"/>
              </a:ext>
            </a:extLst>
          </p:cNvPr>
          <p:cNvGrpSpPr/>
          <p:nvPr/>
        </p:nvGrpSpPr>
        <p:grpSpPr>
          <a:xfrm>
            <a:off x="4118745" y="2221276"/>
            <a:ext cx="1453419" cy="205125"/>
            <a:chOff x="238416" y="2134020"/>
            <a:chExt cx="1453419" cy="205125"/>
          </a:xfrm>
        </p:grpSpPr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2264E69B-5E96-6C2B-157D-B909F99BEBAF}"/>
                </a:ext>
              </a:extLst>
            </p:cNvPr>
            <p:cNvGrpSpPr/>
            <p:nvPr/>
          </p:nvGrpSpPr>
          <p:grpSpPr>
            <a:xfrm>
              <a:off x="238416" y="2134275"/>
              <a:ext cx="122057" cy="204870"/>
              <a:chOff x="248576" y="2050744"/>
              <a:chExt cx="122057" cy="204870"/>
            </a:xfrm>
          </p:grpSpPr>
          <p:sp>
            <p:nvSpPr>
              <p:cNvPr id="144" name="Arrow: Pentagon 143">
                <a:extLst>
                  <a:ext uri="{FF2B5EF4-FFF2-40B4-BE49-F238E27FC236}">
                    <a16:creationId xmlns:a16="http://schemas.microsoft.com/office/drawing/2014/main" id="{02EAB678-CF53-1BEC-D407-7B4884F022F3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pic>
            <p:nvPicPr>
              <p:cNvPr id="145" name="Graphic 144">
                <a:extLst>
                  <a:ext uri="{FF2B5EF4-FFF2-40B4-BE49-F238E27FC236}">
                    <a16:creationId xmlns:a16="http://schemas.microsoft.com/office/drawing/2014/main" id="{2DEEE7AD-3A56-6979-1BFC-0BBA34154E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40666"/>
                <a:ext cx="101898" cy="122054"/>
              </a:xfrm>
              <a:prstGeom prst="rect">
                <a:avLst/>
              </a:prstGeom>
            </p:spPr>
          </p:pic>
        </p:grp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490C7BF8-2D1E-A731-FAEB-0E192AC113E5}"/>
                </a:ext>
              </a:extLst>
            </p:cNvPr>
            <p:cNvSpPr txBox="1"/>
            <p:nvPr/>
          </p:nvSpPr>
          <p:spPr>
            <a:xfrm>
              <a:off x="423796" y="2134020"/>
              <a:ext cx="1268039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chemeClr val="accent2">
                      <a:lumMod val="50000"/>
                    </a:schemeClr>
                  </a:solidFill>
                </a:rPr>
                <a:t>Pigment cell markers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9227D65-1921-55B2-79B9-E0E7D352118B}"/>
              </a:ext>
            </a:extLst>
          </p:cNvPr>
          <p:cNvGrpSpPr/>
          <p:nvPr/>
        </p:nvGrpSpPr>
        <p:grpSpPr>
          <a:xfrm>
            <a:off x="4118745" y="2451379"/>
            <a:ext cx="1530675" cy="249806"/>
            <a:chOff x="4260985" y="2403783"/>
            <a:chExt cx="1530675" cy="249806"/>
          </a:xfrm>
        </p:grpSpPr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9202E51F-C1B7-C76E-E367-1A39CF10F365}"/>
                </a:ext>
              </a:extLst>
            </p:cNvPr>
            <p:cNvSpPr txBox="1"/>
            <p:nvPr/>
          </p:nvSpPr>
          <p:spPr>
            <a:xfrm>
              <a:off x="4446365" y="2499701"/>
              <a:ext cx="1345295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chemeClr val="accent2">
                      <a:lumMod val="50000"/>
                    </a:schemeClr>
                  </a:solidFill>
                </a:rPr>
                <a:t>Th1/2-related markers</a:t>
              </a:r>
            </a:p>
          </p:txBody>
        </p: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C271327B-F5CD-BEE2-D713-86900480D2CC}"/>
                </a:ext>
              </a:extLst>
            </p:cNvPr>
            <p:cNvGrpSpPr/>
            <p:nvPr/>
          </p:nvGrpSpPr>
          <p:grpSpPr>
            <a:xfrm rot="10800000">
              <a:off x="4260985" y="2403783"/>
              <a:ext cx="122057" cy="228934"/>
              <a:chOff x="248576" y="2026680"/>
              <a:chExt cx="122057" cy="228934"/>
            </a:xfrm>
          </p:grpSpPr>
          <p:sp>
            <p:nvSpPr>
              <p:cNvPr id="149" name="Arrow: Pentagon 148">
                <a:extLst>
                  <a:ext uri="{FF2B5EF4-FFF2-40B4-BE49-F238E27FC236}">
                    <a16:creationId xmlns:a16="http://schemas.microsoft.com/office/drawing/2014/main" id="{1FE710A2-EE8A-A8EB-C3A0-51826AFD5FD1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pic>
            <p:nvPicPr>
              <p:cNvPr id="150" name="Graphic 149">
                <a:extLst>
                  <a:ext uri="{FF2B5EF4-FFF2-40B4-BE49-F238E27FC236}">
                    <a16:creationId xmlns:a16="http://schemas.microsoft.com/office/drawing/2014/main" id="{F3E3B14B-8723-06DD-F71F-CB02E057D2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16602"/>
                <a:ext cx="101898" cy="122054"/>
              </a:xfrm>
              <a:prstGeom prst="rect">
                <a:avLst/>
              </a:prstGeom>
            </p:spPr>
          </p:pic>
        </p:grp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3A764317-2813-B8A2-473A-6AA78371D643}"/>
              </a:ext>
            </a:extLst>
          </p:cNvPr>
          <p:cNvGrpSpPr/>
          <p:nvPr/>
        </p:nvGrpSpPr>
        <p:grpSpPr>
          <a:xfrm>
            <a:off x="4118745" y="2639125"/>
            <a:ext cx="1504455" cy="219562"/>
            <a:chOff x="4118745" y="2695046"/>
            <a:chExt cx="1504455" cy="219562"/>
          </a:xfrm>
        </p:grpSpPr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8B242F86-FF63-3D64-57BF-3246E2223A0C}"/>
                </a:ext>
              </a:extLst>
            </p:cNvPr>
            <p:cNvSpPr txBox="1"/>
            <p:nvPr/>
          </p:nvSpPr>
          <p:spPr>
            <a:xfrm>
              <a:off x="4304125" y="2776109"/>
              <a:ext cx="1319075" cy="1384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900" dirty="0">
                  <a:solidFill>
                    <a:schemeClr val="accent2">
                      <a:lumMod val="50000"/>
                    </a:schemeClr>
                  </a:solidFill>
                </a:rPr>
                <a:t>Co-stimulatory molecules</a:t>
              </a:r>
            </a:p>
          </p:txBody>
        </p: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DC61328D-A721-DC80-1EA6-A2745936A30A}"/>
                </a:ext>
              </a:extLst>
            </p:cNvPr>
            <p:cNvGrpSpPr/>
            <p:nvPr/>
          </p:nvGrpSpPr>
          <p:grpSpPr>
            <a:xfrm rot="10800000">
              <a:off x="4118745" y="2695046"/>
              <a:ext cx="122057" cy="204870"/>
              <a:chOff x="248576" y="2050744"/>
              <a:chExt cx="122057" cy="204870"/>
            </a:xfrm>
          </p:grpSpPr>
          <p:sp>
            <p:nvSpPr>
              <p:cNvPr id="154" name="Arrow: Pentagon 153">
                <a:extLst>
                  <a:ext uri="{FF2B5EF4-FFF2-40B4-BE49-F238E27FC236}">
                    <a16:creationId xmlns:a16="http://schemas.microsoft.com/office/drawing/2014/main" id="{FBF1429F-3113-E4E3-5C02-AD6CB8231A83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pic>
            <p:nvPicPr>
              <p:cNvPr id="155" name="Graphic 154">
                <a:extLst>
                  <a:ext uri="{FF2B5EF4-FFF2-40B4-BE49-F238E27FC236}">
                    <a16:creationId xmlns:a16="http://schemas.microsoft.com/office/drawing/2014/main" id="{90CA6D39-8FB5-3B56-7D30-55B676AD47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40666"/>
                <a:ext cx="101898" cy="122054"/>
              </a:xfrm>
              <a:prstGeom prst="rect">
                <a:avLst/>
              </a:prstGeom>
            </p:spPr>
          </p:pic>
        </p:grpSp>
      </p:grpSp>
      <p:sp>
        <p:nvSpPr>
          <p:cNvPr id="174" name="TextBox 173">
            <a:extLst>
              <a:ext uri="{FF2B5EF4-FFF2-40B4-BE49-F238E27FC236}">
                <a16:creationId xmlns:a16="http://schemas.microsoft.com/office/drawing/2014/main" id="{004693AE-692B-7C33-2BF5-FFBD6C11A67B}"/>
              </a:ext>
            </a:extLst>
          </p:cNvPr>
          <p:cNvSpPr txBox="1"/>
          <p:nvPr/>
        </p:nvSpPr>
        <p:spPr>
          <a:xfrm>
            <a:off x="4310023" y="2336997"/>
            <a:ext cx="1173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accent4">
                    <a:lumMod val="50000"/>
                  </a:schemeClr>
                </a:solidFill>
              </a:rPr>
              <a:t>All lesions:</a:t>
            </a:r>
          </a:p>
        </p:txBody>
      </p:sp>
      <p:sp>
        <p:nvSpPr>
          <p:cNvPr id="175" name="Rectangle: Rounded Corners 174">
            <a:extLst>
              <a:ext uri="{FF2B5EF4-FFF2-40B4-BE49-F238E27FC236}">
                <a16:creationId xmlns:a16="http://schemas.microsoft.com/office/drawing/2014/main" id="{961C5214-2C04-8681-8111-7EBA95A8CAFD}"/>
              </a:ext>
            </a:extLst>
          </p:cNvPr>
          <p:cNvSpPr/>
          <p:nvPr/>
        </p:nvSpPr>
        <p:spPr>
          <a:xfrm>
            <a:off x="2435838" y="327341"/>
            <a:ext cx="935459" cy="1190414"/>
          </a:xfrm>
          <a:prstGeom prst="roundRect">
            <a:avLst>
              <a:gd name="adj" fmla="val 8621"/>
            </a:avLst>
          </a:prstGeom>
          <a:solidFill>
            <a:schemeClr val="bg1"/>
          </a:solidFill>
          <a:ln w="6350">
            <a:solidFill>
              <a:schemeClr val="accent1">
                <a:lumMod val="60000"/>
                <a:lumOff val="40000"/>
              </a:schemeClr>
            </a:solidFill>
          </a:ln>
          <a:effectLst>
            <a:outerShdw blurRad="127000" dist="38100" dir="2700000" algn="tl" rotWithShape="0">
              <a:schemeClr val="accent2">
                <a:lumMod val="50000"/>
                <a:alpha val="2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Rectangle: Rounded Corners 175">
            <a:extLst>
              <a:ext uri="{FF2B5EF4-FFF2-40B4-BE49-F238E27FC236}">
                <a16:creationId xmlns:a16="http://schemas.microsoft.com/office/drawing/2014/main" id="{1DF07627-1114-E64E-CCFF-B2FA9818A76C}"/>
              </a:ext>
            </a:extLst>
          </p:cNvPr>
          <p:cNvSpPr/>
          <p:nvPr/>
        </p:nvSpPr>
        <p:spPr>
          <a:xfrm>
            <a:off x="3416080" y="327341"/>
            <a:ext cx="935459" cy="1189924"/>
          </a:xfrm>
          <a:prstGeom prst="roundRect">
            <a:avLst>
              <a:gd name="adj" fmla="val 8621"/>
            </a:avLst>
          </a:prstGeom>
          <a:solidFill>
            <a:schemeClr val="bg1"/>
          </a:solidFill>
          <a:ln w="6350">
            <a:solidFill>
              <a:schemeClr val="accent1">
                <a:lumMod val="60000"/>
                <a:lumOff val="40000"/>
              </a:schemeClr>
            </a:solidFill>
          </a:ln>
          <a:effectLst>
            <a:outerShdw blurRad="127000" dist="38100" dir="2700000" algn="tl" rotWithShape="0">
              <a:schemeClr val="accent2">
                <a:lumMod val="50000"/>
                <a:alpha val="2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Rectangle: Rounded Corners 176">
            <a:extLst>
              <a:ext uri="{FF2B5EF4-FFF2-40B4-BE49-F238E27FC236}">
                <a16:creationId xmlns:a16="http://schemas.microsoft.com/office/drawing/2014/main" id="{BB70B451-D937-C0F9-DA37-2E624C05C563}"/>
              </a:ext>
            </a:extLst>
          </p:cNvPr>
          <p:cNvSpPr/>
          <p:nvPr/>
        </p:nvSpPr>
        <p:spPr>
          <a:xfrm>
            <a:off x="5568177" y="327341"/>
            <a:ext cx="935459" cy="1189216"/>
          </a:xfrm>
          <a:prstGeom prst="roundRect">
            <a:avLst>
              <a:gd name="adj" fmla="val 8621"/>
            </a:avLst>
          </a:prstGeom>
          <a:solidFill>
            <a:schemeClr val="bg1"/>
          </a:solidFill>
          <a:ln w="6350">
            <a:solidFill>
              <a:schemeClr val="accent1">
                <a:lumMod val="60000"/>
                <a:lumOff val="40000"/>
              </a:schemeClr>
            </a:solidFill>
          </a:ln>
          <a:effectLst>
            <a:outerShdw blurRad="127000" dist="38100" dir="2700000" algn="tl" rotWithShape="0">
              <a:schemeClr val="accent2">
                <a:lumMod val="50000"/>
                <a:alpha val="2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Rectangle: Rounded Corners 177">
            <a:extLst>
              <a:ext uri="{FF2B5EF4-FFF2-40B4-BE49-F238E27FC236}">
                <a16:creationId xmlns:a16="http://schemas.microsoft.com/office/drawing/2014/main" id="{9194147D-E42E-2BDF-FE05-1737203751A7}"/>
              </a:ext>
            </a:extLst>
          </p:cNvPr>
          <p:cNvSpPr/>
          <p:nvPr/>
        </p:nvSpPr>
        <p:spPr>
          <a:xfrm>
            <a:off x="6548420" y="327340"/>
            <a:ext cx="935459" cy="1189215"/>
          </a:xfrm>
          <a:prstGeom prst="roundRect">
            <a:avLst>
              <a:gd name="adj" fmla="val 8621"/>
            </a:avLst>
          </a:prstGeom>
          <a:solidFill>
            <a:schemeClr val="bg1"/>
          </a:solidFill>
          <a:ln w="6350">
            <a:solidFill>
              <a:schemeClr val="accent1">
                <a:lumMod val="60000"/>
                <a:lumOff val="40000"/>
              </a:schemeClr>
            </a:solidFill>
          </a:ln>
          <a:effectLst>
            <a:outerShdw blurRad="127000" dist="38100" dir="2700000" algn="tl" rotWithShape="0">
              <a:schemeClr val="accent2">
                <a:lumMod val="50000"/>
                <a:alpha val="2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1B80D1E9-93CB-BE0C-B916-569F0A091FF7}"/>
              </a:ext>
            </a:extLst>
          </p:cNvPr>
          <p:cNvSpPr txBox="1"/>
          <p:nvPr/>
        </p:nvSpPr>
        <p:spPr>
          <a:xfrm>
            <a:off x="4322078" y="1073592"/>
            <a:ext cx="1189959" cy="3847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3/TEC family kinase inhibitor 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14E422E-5C79-2D78-AEC8-9869EE982114}"/>
              </a:ext>
            </a:extLst>
          </p:cNvPr>
          <p:cNvSpPr txBox="1"/>
          <p:nvPr/>
        </p:nvSpPr>
        <p:spPr>
          <a:xfrm>
            <a:off x="4663026" y="514596"/>
            <a:ext cx="775893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tlecitinib</a:t>
            </a:r>
          </a:p>
          <a:p>
            <a:r>
              <a:rPr lang="en-US" sz="9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ily </a:t>
            </a:r>
            <a:br>
              <a:rPr lang="en-US" sz="9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weeks</a:t>
            </a:r>
            <a:endParaRPr lang="en-US" sz="9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pic>
        <p:nvPicPr>
          <p:cNvPr id="187" name="Graphic 186">
            <a:extLst>
              <a:ext uri="{FF2B5EF4-FFF2-40B4-BE49-F238E27FC236}">
                <a16:creationId xmlns:a16="http://schemas.microsoft.com/office/drawing/2014/main" id="{57761AD5-8A29-2CF8-27B8-673644C9B8E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510066" y="666401"/>
            <a:ext cx="204220" cy="204220"/>
          </a:xfrm>
          <a:prstGeom prst="rect">
            <a:avLst/>
          </a:prstGeom>
        </p:spPr>
      </p:pic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91B52AF4-A593-A80F-4C79-E4FAAA2DF950}"/>
              </a:ext>
            </a:extLst>
          </p:cNvPr>
          <p:cNvCxnSpPr>
            <a:cxnSpLocks/>
          </p:cNvCxnSpPr>
          <p:nvPr/>
        </p:nvCxnSpPr>
        <p:spPr>
          <a:xfrm>
            <a:off x="3810000" y="1558593"/>
            <a:ext cx="0" cy="1180093"/>
          </a:xfrm>
          <a:prstGeom prst="line">
            <a:avLst/>
          </a:prstGeom>
          <a:ln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45259A1C-9A20-83B6-43E5-7EB8FADF1551}"/>
              </a:ext>
            </a:extLst>
          </p:cNvPr>
          <p:cNvSpPr txBox="1"/>
          <p:nvPr/>
        </p:nvSpPr>
        <p:spPr>
          <a:xfrm>
            <a:off x="2491978" y="1108046"/>
            <a:ext cx="823179" cy="3847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e lesions: </a:t>
            </a:r>
          </a:p>
          <a:p>
            <a:pPr algn="ctr"/>
            <a:r>
              <a:rPr lang="en-US" sz="800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reading depigmentation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A2C34E43-79F1-877B-BEC9-AA5FD90A04AD}"/>
              </a:ext>
            </a:extLst>
          </p:cNvPr>
          <p:cNvSpPr txBox="1"/>
          <p:nvPr/>
        </p:nvSpPr>
        <p:spPr>
          <a:xfrm>
            <a:off x="3472220" y="1108046"/>
            <a:ext cx="823179" cy="26161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le lesions: </a:t>
            </a:r>
            <a:br>
              <a:rPr lang="en-US" sz="9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800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spreading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5C782538-0970-0D44-EBF4-2DD3D7B7C338}"/>
              </a:ext>
            </a:extLst>
          </p:cNvPr>
          <p:cNvSpPr txBox="1"/>
          <p:nvPr/>
        </p:nvSpPr>
        <p:spPr>
          <a:xfrm>
            <a:off x="5624317" y="1108046"/>
            <a:ext cx="823179" cy="3847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e lesions: </a:t>
            </a:r>
          </a:p>
          <a:p>
            <a:pPr algn="ctr"/>
            <a:r>
              <a:rPr lang="en-US" sz="800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ilized depigmentation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22546799-B497-BAFC-AAA4-A150B1177D58}"/>
              </a:ext>
            </a:extLst>
          </p:cNvPr>
          <p:cNvSpPr txBox="1"/>
          <p:nvPr/>
        </p:nvSpPr>
        <p:spPr>
          <a:xfrm>
            <a:off x="6604560" y="1108046"/>
            <a:ext cx="823179" cy="26161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le lesions: </a:t>
            </a:r>
          </a:p>
          <a:p>
            <a:pPr algn="ctr"/>
            <a:r>
              <a:rPr lang="en-US" sz="800" dirty="0" err="1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igmentation</a:t>
            </a:r>
            <a:endParaRPr lang="en-US" sz="800" dirty="0">
              <a:solidFill>
                <a:schemeClr val="accent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D4BD8999-2606-DDF9-B82B-1713C9C5DDEC}"/>
              </a:ext>
            </a:extLst>
          </p:cNvPr>
          <p:cNvCxnSpPr>
            <a:cxnSpLocks/>
          </p:cNvCxnSpPr>
          <p:nvPr/>
        </p:nvCxnSpPr>
        <p:spPr>
          <a:xfrm>
            <a:off x="0" y="241991"/>
            <a:ext cx="7620001" cy="0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Graphic 24">
            <a:extLst>
              <a:ext uri="{FF2B5EF4-FFF2-40B4-BE49-F238E27FC236}">
                <a16:creationId xmlns:a16="http://schemas.microsoft.com/office/drawing/2014/main" id="{27C1D279-B463-00D9-46BE-D28CE1BEB3C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15638" y="342676"/>
            <a:ext cx="500229" cy="824928"/>
          </a:xfrm>
          <a:prstGeom prst="rect">
            <a:avLst/>
          </a:prstGeom>
        </p:spPr>
      </p:pic>
      <p:pic>
        <p:nvPicPr>
          <p:cNvPr id="3" name="Graphic 24">
            <a:extLst>
              <a:ext uri="{FF2B5EF4-FFF2-40B4-BE49-F238E27FC236}">
                <a16:creationId xmlns:a16="http://schemas.microsoft.com/office/drawing/2014/main" id="{0E2FF895-182A-4377-A362-FBD0AEBD08B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95880" y="342675"/>
            <a:ext cx="500228" cy="824927"/>
          </a:xfrm>
          <a:prstGeom prst="rect">
            <a:avLst/>
          </a:prstGeom>
        </p:spPr>
      </p:pic>
      <p:pic>
        <p:nvPicPr>
          <p:cNvPr id="4" name="Graphic 24">
            <a:extLst>
              <a:ext uri="{FF2B5EF4-FFF2-40B4-BE49-F238E27FC236}">
                <a16:creationId xmlns:a16="http://schemas.microsoft.com/office/drawing/2014/main" id="{80964617-D5DE-E7C7-1EE9-6DC205B69E1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47977" y="342675"/>
            <a:ext cx="500228" cy="824927"/>
          </a:xfrm>
          <a:prstGeom prst="rect">
            <a:avLst/>
          </a:prstGeom>
        </p:spPr>
      </p:pic>
      <p:pic>
        <p:nvPicPr>
          <p:cNvPr id="5" name="Graphic 24">
            <a:extLst>
              <a:ext uri="{FF2B5EF4-FFF2-40B4-BE49-F238E27FC236}">
                <a16:creationId xmlns:a16="http://schemas.microsoft.com/office/drawing/2014/main" id="{15936BF9-9A56-7937-E965-EA3B3EF36E1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728220" y="342675"/>
            <a:ext cx="500228" cy="824927"/>
          </a:xfrm>
          <a:prstGeom prst="rect">
            <a:avLst/>
          </a:prstGeom>
        </p:spPr>
      </p:pic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E4BCF101-0B0A-DDE7-844F-2CA96F6D513F}"/>
              </a:ext>
            </a:extLst>
          </p:cNvPr>
          <p:cNvSpPr/>
          <p:nvPr/>
        </p:nvSpPr>
        <p:spPr>
          <a:xfrm>
            <a:off x="1037049" y="1781044"/>
            <a:ext cx="389266" cy="234739"/>
          </a:xfrm>
          <a:prstGeom prst="roundRect">
            <a:avLst/>
          </a:prstGeom>
          <a:solidFill>
            <a:schemeClr val="bg1"/>
          </a:solidFill>
          <a:ln>
            <a:solidFill>
              <a:srgbClr val="66AF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288" tIns="18288" rIns="18288" bIns="18288" rtlCol="0" anchor="ctr"/>
          <a:lstStyle/>
          <a:p>
            <a:pPr algn="ctr"/>
            <a:r>
              <a:rPr lang="en-US" sz="1000" b="1" dirty="0">
                <a:solidFill>
                  <a:schemeClr val="accent4"/>
                </a:solidFill>
              </a:rPr>
              <a:t>Skin</a:t>
            </a: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3330513E-50BE-AEEA-4A93-EC73D9D0378B}"/>
              </a:ext>
            </a:extLst>
          </p:cNvPr>
          <p:cNvSpPr/>
          <p:nvPr/>
        </p:nvSpPr>
        <p:spPr>
          <a:xfrm>
            <a:off x="4846448" y="1781044"/>
            <a:ext cx="389266" cy="234739"/>
          </a:xfrm>
          <a:prstGeom prst="roundRect">
            <a:avLst/>
          </a:prstGeom>
          <a:solidFill>
            <a:schemeClr val="bg1"/>
          </a:solidFill>
          <a:ln>
            <a:solidFill>
              <a:srgbClr val="66AF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288" tIns="18288" rIns="18288" bIns="18288" rtlCol="0" anchor="ctr"/>
          <a:lstStyle/>
          <a:p>
            <a:pPr algn="ctr"/>
            <a:r>
              <a:rPr lang="en-US" sz="1000" b="1" dirty="0">
                <a:solidFill>
                  <a:schemeClr val="accent4"/>
                </a:solidFill>
              </a:rPr>
              <a:t>Skin</a:t>
            </a:r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57BE35E6-605A-CE24-2F72-0AB8F4EDBA68}"/>
              </a:ext>
            </a:extLst>
          </p:cNvPr>
          <p:cNvSpPr/>
          <p:nvPr/>
        </p:nvSpPr>
        <p:spPr>
          <a:xfrm>
            <a:off x="6538310" y="1781044"/>
            <a:ext cx="420460" cy="234739"/>
          </a:xfrm>
          <a:prstGeom prst="roundRect">
            <a:avLst/>
          </a:prstGeom>
          <a:solidFill>
            <a:schemeClr val="bg1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288" tIns="18288" rIns="18288" bIns="18288" rtlCol="0" anchor="ctr"/>
          <a:lstStyle/>
          <a:p>
            <a:pPr algn="ctr"/>
            <a:r>
              <a:rPr lang="en-US" sz="1000" b="1" dirty="0">
                <a:solidFill>
                  <a:schemeClr val="accent3"/>
                </a:solidFill>
              </a:rPr>
              <a:t>Blood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97625C3F-B731-9988-BF53-D082F06A9EFD}"/>
              </a:ext>
            </a:extLst>
          </p:cNvPr>
          <p:cNvGrpSpPr/>
          <p:nvPr/>
        </p:nvGrpSpPr>
        <p:grpSpPr>
          <a:xfrm rot="2028813">
            <a:off x="2858465" y="713579"/>
            <a:ext cx="45719" cy="101651"/>
            <a:chOff x="2404039" y="294513"/>
            <a:chExt cx="45719" cy="101651"/>
          </a:xfrm>
        </p:grpSpPr>
        <p:sp>
          <p:nvSpPr>
            <p:cNvPr id="22" name="Isosceles Triangle 21">
              <a:extLst>
                <a:ext uri="{FF2B5EF4-FFF2-40B4-BE49-F238E27FC236}">
                  <a16:creationId xmlns:a16="http://schemas.microsoft.com/office/drawing/2014/main" id="{423C65B3-4A74-70D9-4636-379637C6DF5B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1DC1F01-3ABF-19F4-95FC-7CC48DFD37FE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1B12A745-1E10-9675-46E9-C6B23A9AF8F3}"/>
              </a:ext>
            </a:extLst>
          </p:cNvPr>
          <p:cNvGrpSpPr/>
          <p:nvPr/>
        </p:nvGrpSpPr>
        <p:grpSpPr>
          <a:xfrm rot="7434869">
            <a:off x="2865585" y="828646"/>
            <a:ext cx="45719" cy="101651"/>
            <a:chOff x="2404039" y="294513"/>
            <a:chExt cx="45719" cy="101651"/>
          </a:xfrm>
        </p:grpSpPr>
        <p:sp>
          <p:nvSpPr>
            <p:cNvPr id="36" name="Isosceles Triangle 35">
              <a:extLst>
                <a:ext uri="{FF2B5EF4-FFF2-40B4-BE49-F238E27FC236}">
                  <a16:creationId xmlns:a16="http://schemas.microsoft.com/office/drawing/2014/main" id="{DEDF7950-F8C0-C764-0528-16CF4E1A2707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51A2435B-73F9-37BD-578A-0F8DDF918FE8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D4B5F51E-6BE7-4664-6C32-5AE7B054067F}"/>
              </a:ext>
            </a:extLst>
          </p:cNvPr>
          <p:cNvGrpSpPr/>
          <p:nvPr/>
        </p:nvGrpSpPr>
        <p:grpSpPr>
          <a:xfrm rot="13249606">
            <a:off x="2766059" y="825929"/>
            <a:ext cx="45719" cy="101651"/>
            <a:chOff x="2404039" y="294513"/>
            <a:chExt cx="45719" cy="101651"/>
          </a:xfrm>
        </p:grpSpPr>
        <p:sp>
          <p:nvSpPr>
            <p:cNvPr id="43" name="Isosceles Triangle 42">
              <a:extLst>
                <a:ext uri="{FF2B5EF4-FFF2-40B4-BE49-F238E27FC236}">
                  <a16:creationId xmlns:a16="http://schemas.microsoft.com/office/drawing/2014/main" id="{6CB53507-6204-C3AD-9771-DBFF48BEA9F9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A7D1B1C5-45A4-4970-3DE8-49877DC9ACA1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CD331DEC-9ED7-A85B-9B25-FB43F568C956}"/>
              </a:ext>
            </a:extLst>
          </p:cNvPr>
          <p:cNvGrpSpPr/>
          <p:nvPr/>
        </p:nvGrpSpPr>
        <p:grpSpPr>
          <a:xfrm rot="18339937">
            <a:off x="2756167" y="735841"/>
            <a:ext cx="45719" cy="101651"/>
            <a:chOff x="2404039" y="294513"/>
            <a:chExt cx="45719" cy="101651"/>
          </a:xfrm>
        </p:grpSpPr>
        <p:sp>
          <p:nvSpPr>
            <p:cNvPr id="47" name="Isosceles Triangle 46">
              <a:extLst>
                <a:ext uri="{FF2B5EF4-FFF2-40B4-BE49-F238E27FC236}">
                  <a16:creationId xmlns:a16="http://schemas.microsoft.com/office/drawing/2014/main" id="{F6F5B751-86BC-082D-C848-FE0986CBCA7A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356F4325-3F30-2FA1-364D-E949AE534D61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F0A0AA49-9174-FA1D-B6A2-AD0E937B68FD}"/>
              </a:ext>
            </a:extLst>
          </p:cNvPr>
          <p:cNvGrpSpPr/>
          <p:nvPr/>
        </p:nvGrpSpPr>
        <p:grpSpPr>
          <a:xfrm rot="14117887">
            <a:off x="6963718" y="700276"/>
            <a:ext cx="45719" cy="101651"/>
            <a:chOff x="2404039" y="294513"/>
            <a:chExt cx="45719" cy="101651"/>
          </a:xfrm>
        </p:grpSpPr>
        <p:sp>
          <p:nvSpPr>
            <p:cNvPr id="50" name="Isosceles Triangle 49">
              <a:extLst>
                <a:ext uri="{FF2B5EF4-FFF2-40B4-BE49-F238E27FC236}">
                  <a16:creationId xmlns:a16="http://schemas.microsoft.com/office/drawing/2014/main" id="{BC0A4184-1FBE-2227-CF82-F86775269B3C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6248059D-F0AE-0EB8-D208-8AFE33A3C83E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6BEEFDD9-BB5E-8BE1-B256-B987EB7EE2D0}"/>
              </a:ext>
            </a:extLst>
          </p:cNvPr>
          <p:cNvGrpSpPr/>
          <p:nvPr/>
        </p:nvGrpSpPr>
        <p:grpSpPr>
          <a:xfrm rot="19800717">
            <a:off x="6960506" y="820720"/>
            <a:ext cx="45719" cy="101651"/>
            <a:chOff x="2404039" y="294513"/>
            <a:chExt cx="45719" cy="101651"/>
          </a:xfrm>
        </p:grpSpPr>
        <p:sp>
          <p:nvSpPr>
            <p:cNvPr id="53" name="Isosceles Triangle 52">
              <a:extLst>
                <a:ext uri="{FF2B5EF4-FFF2-40B4-BE49-F238E27FC236}">
                  <a16:creationId xmlns:a16="http://schemas.microsoft.com/office/drawing/2014/main" id="{FDD898D5-F482-3388-6830-3DB9298B0433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5A427C5B-910B-0E8F-89D6-813762381069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63FE98D6-9BF7-290D-B89C-AE93ED371746}"/>
              </a:ext>
            </a:extLst>
          </p:cNvPr>
          <p:cNvGrpSpPr/>
          <p:nvPr/>
        </p:nvGrpSpPr>
        <p:grpSpPr>
          <a:xfrm rot="3636944">
            <a:off x="6872120" y="817646"/>
            <a:ext cx="45719" cy="101651"/>
            <a:chOff x="2404039" y="294513"/>
            <a:chExt cx="45719" cy="101651"/>
          </a:xfrm>
        </p:grpSpPr>
        <p:sp>
          <p:nvSpPr>
            <p:cNvPr id="56" name="Isosceles Triangle 55">
              <a:extLst>
                <a:ext uri="{FF2B5EF4-FFF2-40B4-BE49-F238E27FC236}">
                  <a16:creationId xmlns:a16="http://schemas.microsoft.com/office/drawing/2014/main" id="{65D1084D-4B24-8BF4-E09D-49DA798B1FAA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644867FB-0D3B-16E5-1518-183E0BB63E41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6D068D2C-0606-DBBC-46E5-82B5E41FBFB8}"/>
              </a:ext>
            </a:extLst>
          </p:cNvPr>
          <p:cNvGrpSpPr/>
          <p:nvPr/>
        </p:nvGrpSpPr>
        <p:grpSpPr>
          <a:xfrm rot="6968689">
            <a:off x="6872120" y="739541"/>
            <a:ext cx="45719" cy="101651"/>
            <a:chOff x="2404039" y="294513"/>
            <a:chExt cx="45719" cy="101651"/>
          </a:xfrm>
        </p:grpSpPr>
        <p:sp>
          <p:nvSpPr>
            <p:cNvPr id="59" name="Isosceles Triangle 58">
              <a:extLst>
                <a:ext uri="{FF2B5EF4-FFF2-40B4-BE49-F238E27FC236}">
                  <a16:creationId xmlns:a16="http://schemas.microsoft.com/office/drawing/2014/main" id="{04EC5A8E-48AF-B4A1-50E3-697CDC3379EC}"/>
                </a:ext>
              </a:extLst>
            </p:cNvPr>
            <p:cNvSpPr/>
            <p:nvPr/>
          </p:nvSpPr>
          <p:spPr>
            <a:xfrm>
              <a:off x="2404039" y="294513"/>
              <a:ext cx="45719" cy="50524"/>
            </a:xfrm>
            <a:prstGeom prst="triangle">
              <a:avLst/>
            </a:prstGeom>
            <a:solidFill>
              <a:srgbClr val="2C529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141FCCDF-8B5A-5645-6DA1-8A53AA593F11}"/>
                </a:ext>
              </a:extLst>
            </p:cNvPr>
            <p:cNvCxnSpPr>
              <a:cxnSpLocks/>
            </p:cNvCxnSpPr>
            <p:nvPr/>
          </p:nvCxnSpPr>
          <p:spPr>
            <a:xfrm>
              <a:off x="2425596" y="319501"/>
              <a:ext cx="0" cy="76663"/>
            </a:xfrm>
            <a:prstGeom prst="line">
              <a:avLst/>
            </a:prstGeom>
            <a:ln w="9525">
              <a:solidFill>
                <a:srgbClr val="2C52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2F906098-755C-B576-4BD9-8C4E2DDA1B6E}"/>
              </a:ext>
            </a:extLst>
          </p:cNvPr>
          <p:cNvSpPr txBox="1"/>
          <p:nvPr/>
        </p:nvSpPr>
        <p:spPr>
          <a:xfrm>
            <a:off x="2236825" y="2663399"/>
            <a:ext cx="129249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chemeClr val="accent2">
                    <a:lumMod val="50000"/>
                  </a:schemeClr>
                </a:solidFill>
              </a:rPr>
              <a:t>Immune inhibition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14AAE28E-A2A4-9183-EB72-75DD520F8886}"/>
              </a:ext>
            </a:extLst>
          </p:cNvPr>
          <p:cNvGrpSpPr/>
          <p:nvPr/>
        </p:nvGrpSpPr>
        <p:grpSpPr>
          <a:xfrm>
            <a:off x="4118745" y="2789079"/>
            <a:ext cx="1530675" cy="249806"/>
            <a:chOff x="4260985" y="2403783"/>
            <a:chExt cx="1530675" cy="249806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131D0420-7585-0A3D-EC13-A689F62140C3}"/>
                </a:ext>
              </a:extLst>
            </p:cNvPr>
            <p:cNvSpPr txBox="1"/>
            <p:nvPr/>
          </p:nvSpPr>
          <p:spPr>
            <a:xfrm>
              <a:off x="4446365" y="2499701"/>
              <a:ext cx="1345295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chemeClr val="accent2">
                      <a:lumMod val="50000"/>
                    </a:schemeClr>
                  </a:solidFill>
                </a:rPr>
                <a:t>T-cell number</a:t>
              </a:r>
            </a:p>
          </p:txBody>
        </p: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F4621692-347A-5FC5-B2FB-8B2CBBEC5DCA}"/>
                </a:ext>
              </a:extLst>
            </p:cNvPr>
            <p:cNvGrpSpPr/>
            <p:nvPr/>
          </p:nvGrpSpPr>
          <p:grpSpPr>
            <a:xfrm rot="10800000">
              <a:off x="4260985" y="2403783"/>
              <a:ext cx="122057" cy="228934"/>
              <a:chOff x="248576" y="2026680"/>
              <a:chExt cx="122057" cy="228934"/>
            </a:xfrm>
          </p:grpSpPr>
          <p:sp>
            <p:nvSpPr>
              <p:cNvPr id="63" name="Arrow: Pentagon 62">
                <a:extLst>
                  <a:ext uri="{FF2B5EF4-FFF2-40B4-BE49-F238E27FC236}">
                    <a16:creationId xmlns:a16="http://schemas.microsoft.com/office/drawing/2014/main" id="{E3319972-2888-E182-05FB-2C6211762DAF}"/>
                  </a:ext>
                </a:extLst>
              </p:cNvPr>
              <p:cNvSpPr/>
              <p:nvPr/>
            </p:nvSpPr>
            <p:spPr>
              <a:xfrm rot="16200000">
                <a:off x="223427" y="2108408"/>
                <a:ext cx="172358" cy="122054"/>
              </a:xfrm>
              <a:prstGeom prst="homePlate">
                <a:avLst/>
              </a:prstGeom>
              <a:gradFill>
                <a:gsLst>
                  <a:gs pos="0">
                    <a:srgbClr val="F0EDF3">
                      <a:alpha val="0"/>
                    </a:srgbClr>
                  </a:gs>
                  <a:gs pos="100000">
                    <a:schemeClr val="accent2"/>
                  </a:gs>
                </a:gsLst>
                <a:lin ang="21594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pic>
            <p:nvPicPr>
              <p:cNvPr id="64" name="Graphic 63">
                <a:extLst>
                  <a:ext uri="{FF2B5EF4-FFF2-40B4-BE49-F238E27FC236}">
                    <a16:creationId xmlns:a16="http://schemas.microsoft.com/office/drawing/2014/main" id="{D0CDB2E4-B95A-CDC4-4FE3-69F965610F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5400000">
                <a:off x="258654" y="2016602"/>
                <a:ext cx="101898" cy="122054"/>
              </a:xfrm>
              <a:prstGeom prst="rect">
                <a:avLst/>
              </a:prstGeom>
            </p:spPr>
          </p:pic>
        </p:grpSp>
      </p:grpSp>
      <p:sp>
        <p:nvSpPr>
          <p:cNvPr id="203" name="Rectangle: Rounded Corners 202">
            <a:extLst>
              <a:ext uri="{FF2B5EF4-FFF2-40B4-BE49-F238E27FC236}">
                <a16:creationId xmlns:a16="http://schemas.microsoft.com/office/drawing/2014/main" id="{67BD2596-2745-1073-6293-3048F01CCB74}"/>
              </a:ext>
            </a:extLst>
          </p:cNvPr>
          <p:cNvSpPr/>
          <p:nvPr/>
        </p:nvSpPr>
        <p:spPr>
          <a:xfrm>
            <a:off x="1999485" y="1845084"/>
            <a:ext cx="1549101" cy="1188720"/>
          </a:xfrm>
          <a:prstGeom prst="roundRect">
            <a:avLst>
              <a:gd name="adj" fmla="val 9307"/>
            </a:avLst>
          </a:prstGeom>
          <a:noFill/>
          <a:ln>
            <a:solidFill>
              <a:srgbClr val="9AB5E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27D488B0-9EF5-9B5F-56B1-CC728B0430D2}"/>
              </a:ext>
            </a:extLst>
          </p:cNvPr>
          <p:cNvSpPr/>
          <p:nvPr/>
        </p:nvSpPr>
        <p:spPr>
          <a:xfrm>
            <a:off x="2724878" y="1781044"/>
            <a:ext cx="420460" cy="234739"/>
          </a:xfrm>
          <a:prstGeom prst="roundRect">
            <a:avLst/>
          </a:prstGeom>
          <a:solidFill>
            <a:schemeClr val="bg1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288" tIns="18288" rIns="18288" bIns="18288" rtlCol="0" anchor="ctr"/>
          <a:lstStyle/>
          <a:p>
            <a:pPr algn="ctr"/>
            <a:r>
              <a:rPr lang="en-US" sz="1000" b="1" dirty="0">
                <a:solidFill>
                  <a:schemeClr val="accent3"/>
                </a:solidFill>
              </a:rPr>
              <a:t>Blood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7668A308-B520-28F5-6F58-509AC482EC96}"/>
              </a:ext>
            </a:extLst>
          </p:cNvPr>
          <p:cNvGrpSpPr/>
          <p:nvPr/>
        </p:nvGrpSpPr>
        <p:grpSpPr>
          <a:xfrm>
            <a:off x="2419881" y="1759830"/>
            <a:ext cx="270769" cy="270769"/>
            <a:chOff x="2895600" y="2445058"/>
            <a:chExt cx="270769" cy="270769"/>
          </a:xfrm>
        </p:grpSpPr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50B3D177-3E2F-9497-CFD7-3AF6172A4597}"/>
                </a:ext>
              </a:extLst>
            </p:cNvPr>
            <p:cNvSpPr/>
            <p:nvPr/>
          </p:nvSpPr>
          <p:spPr>
            <a:xfrm>
              <a:off x="2895600" y="2445058"/>
              <a:ext cx="270769" cy="270769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F9EE13E2-6234-6738-8492-996A3C9AB1D8}"/>
                </a:ext>
              </a:extLst>
            </p:cNvPr>
            <p:cNvGrpSpPr/>
            <p:nvPr/>
          </p:nvGrpSpPr>
          <p:grpSpPr>
            <a:xfrm>
              <a:off x="2968471" y="2497107"/>
              <a:ext cx="125027" cy="166670"/>
              <a:chOff x="5652486" y="2326441"/>
              <a:chExt cx="125027" cy="166670"/>
            </a:xfrm>
            <a:solidFill>
              <a:schemeClr val="bg1"/>
            </a:solidFill>
          </p:grpSpPr>
          <p:sp>
            <p:nvSpPr>
              <p:cNvPr id="33" name="Freeform: Shape 32">
                <a:extLst>
                  <a:ext uri="{FF2B5EF4-FFF2-40B4-BE49-F238E27FC236}">
                    <a16:creationId xmlns:a16="http://schemas.microsoft.com/office/drawing/2014/main" id="{AF982D81-7DCF-7862-FA65-CD3B5D243B2E}"/>
                  </a:ext>
                </a:extLst>
              </p:cNvPr>
              <p:cNvSpPr/>
              <p:nvPr/>
            </p:nvSpPr>
            <p:spPr>
              <a:xfrm>
                <a:off x="5652486" y="2326441"/>
                <a:ext cx="125027" cy="166670"/>
              </a:xfrm>
              <a:custGeom>
                <a:avLst/>
                <a:gdLst>
                  <a:gd name="connsiteX0" fmla="*/ 62514 w 125027"/>
                  <a:gd name="connsiteY0" fmla="*/ 166668 h 166670"/>
                  <a:gd name="connsiteX1" fmla="*/ 18587 w 125027"/>
                  <a:gd name="connsiteY1" fmla="*/ 148964 h 166670"/>
                  <a:gd name="connsiteX2" fmla="*/ 0 w 125027"/>
                  <a:gd name="connsiteY2" fmla="*/ 105405 h 166670"/>
                  <a:gd name="connsiteX3" fmla="*/ 59874 w 125027"/>
                  <a:gd name="connsiteY3" fmla="*/ 1216 h 166670"/>
                  <a:gd name="connsiteX4" fmla="*/ 62514 w 125027"/>
                  <a:gd name="connsiteY4" fmla="*/ 0 h 166670"/>
                  <a:gd name="connsiteX5" fmla="*/ 65153 w 125027"/>
                  <a:gd name="connsiteY5" fmla="*/ 1216 h 166670"/>
                  <a:gd name="connsiteX6" fmla="*/ 125027 w 125027"/>
                  <a:gd name="connsiteY6" fmla="*/ 105405 h 166670"/>
                  <a:gd name="connsiteX7" fmla="*/ 106440 w 125027"/>
                  <a:gd name="connsiteY7" fmla="*/ 148964 h 166670"/>
                  <a:gd name="connsiteX8" fmla="*/ 62514 w 125027"/>
                  <a:gd name="connsiteY8" fmla="*/ 166668 h 166670"/>
                  <a:gd name="connsiteX9" fmla="*/ 62514 w 125027"/>
                  <a:gd name="connsiteY9" fmla="*/ 8884 h 166670"/>
                  <a:gd name="connsiteX10" fmla="*/ 6946 w 125027"/>
                  <a:gd name="connsiteY10" fmla="*/ 105398 h 166670"/>
                  <a:gd name="connsiteX11" fmla="*/ 23509 w 125027"/>
                  <a:gd name="connsiteY11" fmla="*/ 144036 h 166670"/>
                  <a:gd name="connsiteX12" fmla="*/ 62514 w 125027"/>
                  <a:gd name="connsiteY12" fmla="*/ 159715 h 166670"/>
                  <a:gd name="connsiteX13" fmla="*/ 101518 w 125027"/>
                  <a:gd name="connsiteY13" fmla="*/ 144036 h 166670"/>
                  <a:gd name="connsiteX14" fmla="*/ 118081 w 125027"/>
                  <a:gd name="connsiteY14" fmla="*/ 105398 h 166670"/>
                  <a:gd name="connsiteX15" fmla="*/ 62514 w 125027"/>
                  <a:gd name="connsiteY15" fmla="*/ 8884 h 1666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25027" h="166670">
                    <a:moveTo>
                      <a:pt x="62514" y="166668"/>
                    </a:moveTo>
                    <a:cubicBezTo>
                      <a:pt x="46104" y="166817"/>
                      <a:pt x="30308" y="160449"/>
                      <a:pt x="18587" y="148964"/>
                    </a:cubicBezTo>
                    <a:cubicBezTo>
                      <a:pt x="6868" y="137479"/>
                      <a:pt x="183" y="121813"/>
                      <a:pt x="0" y="105405"/>
                    </a:cubicBezTo>
                    <a:cubicBezTo>
                      <a:pt x="0" y="72620"/>
                      <a:pt x="57408" y="4098"/>
                      <a:pt x="59874" y="1216"/>
                    </a:cubicBezTo>
                    <a:cubicBezTo>
                      <a:pt x="60534" y="445"/>
                      <a:pt x="61498" y="0"/>
                      <a:pt x="62514" y="0"/>
                    </a:cubicBezTo>
                    <a:cubicBezTo>
                      <a:pt x="63529" y="0"/>
                      <a:pt x="64493" y="445"/>
                      <a:pt x="65153" y="1216"/>
                    </a:cubicBezTo>
                    <a:cubicBezTo>
                      <a:pt x="67619" y="4098"/>
                      <a:pt x="125027" y="72620"/>
                      <a:pt x="125027" y="105405"/>
                    </a:cubicBezTo>
                    <a:cubicBezTo>
                      <a:pt x="124844" y="121813"/>
                      <a:pt x="118159" y="137479"/>
                      <a:pt x="106440" y="148964"/>
                    </a:cubicBezTo>
                    <a:cubicBezTo>
                      <a:pt x="94720" y="160450"/>
                      <a:pt x="78923" y="166817"/>
                      <a:pt x="62514" y="166668"/>
                    </a:cubicBezTo>
                    <a:close/>
                    <a:moveTo>
                      <a:pt x="62514" y="8884"/>
                    </a:moveTo>
                    <a:cubicBezTo>
                      <a:pt x="51122" y="22776"/>
                      <a:pt x="6946" y="78899"/>
                      <a:pt x="6946" y="105398"/>
                    </a:cubicBezTo>
                    <a:cubicBezTo>
                      <a:pt x="7138" y="119961"/>
                      <a:pt x="13094" y="133854"/>
                      <a:pt x="23509" y="144036"/>
                    </a:cubicBezTo>
                    <a:cubicBezTo>
                      <a:pt x="33924" y="154217"/>
                      <a:pt x="47949" y="159854"/>
                      <a:pt x="62514" y="159715"/>
                    </a:cubicBezTo>
                    <a:cubicBezTo>
                      <a:pt x="77078" y="159854"/>
                      <a:pt x="91103" y="154216"/>
                      <a:pt x="101518" y="144036"/>
                    </a:cubicBezTo>
                    <a:cubicBezTo>
                      <a:pt x="111933" y="133854"/>
                      <a:pt x="117889" y="119961"/>
                      <a:pt x="118081" y="105398"/>
                    </a:cubicBezTo>
                    <a:cubicBezTo>
                      <a:pt x="118081" y="78899"/>
                      <a:pt x="73905" y="22915"/>
                      <a:pt x="62514" y="8884"/>
                    </a:cubicBezTo>
                    <a:close/>
                  </a:path>
                </a:pathLst>
              </a:custGeom>
              <a:grpFill/>
              <a:ln w="138" cap="flat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8" name="Freeform: Shape 37">
                <a:extLst>
                  <a:ext uri="{FF2B5EF4-FFF2-40B4-BE49-F238E27FC236}">
                    <a16:creationId xmlns:a16="http://schemas.microsoft.com/office/drawing/2014/main" id="{689E9FF5-4325-2F61-A5FB-69A745A67C88}"/>
                  </a:ext>
                </a:extLst>
              </p:cNvPr>
              <p:cNvSpPr/>
              <p:nvPr/>
            </p:nvSpPr>
            <p:spPr>
              <a:xfrm>
                <a:off x="5732385" y="2428366"/>
                <a:ext cx="31235" cy="45877"/>
              </a:xfrm>
              <a:custGeom>
                <a:avLst/>
                <a:gdLst>
                  <a:gd name="connsiteX0" fmla="*/ 3452 w 31235"/>
                  <a:gd name="connsiteY0" fmla="*/ 45877 h 45877"/>
                  <a:gd name="connsiteX1" fmla="*/ 767 w 31235"/>
                  <a:gd name="connsiteY1" fmla="*/ 44581 h 45877"/>
                  <a:gd name="connsiteX2" fmla="*/ 76 w 31235"/>
                  <a:gd name="connsiteY2" fmla="*/ 41681 h 45877"/>
                  <a:gd name="connsiteX3" fmla="*/ 1889 w 31235"/>
                  <a:gd name="connsiteY3" fmla="*/ 39313 h 45877"/>
                  <a:gd name="connsiteX4" fmla="*/ 18178 w 31235"/>
                  <a:gd name="connsiteY4" fmla="*/ 24573 h 45877"/>
                  <a:gd name="connsiteX5" fmla="*/ 24290 w 31235"/>
                  <a:gd name="connsiteY5" fmla="*/ 3472 h 45877"/>
                  <a:gd name="connsiteX6" fmla="*/ 26026 w 31235"/>
                  <a:gd name="connsiteY6" fmla="*/ 465 h 45877"/>
                  <a:gd name="connsiteX7" fmla="*/ 29499 w 31235"/>
                  <a:gd name="connsiteY7" fmla="*/ 465 h 45877"/>
                  <a:gd name="connsiteX8" fmla="*/ 31236 w 31235"/>
                  <a:gd name="connsiteY8" fmla="*/ 3472 h 45877"/>
                  <a:gd name="connsiteX9" fmla="*/ 24097 w 31235"/>
                  <a:gd name="connsiteY9" fmla="*/ 28210 h 45877"/>
                  <a:gd name="connsiteX10" fmla="*/ 5015 w 31235"/>
                  <a:gd name="connsiteY10" fmla="*/ 45495 h 45877"/>
                  <a:gd name="connsiteX11" fmla="*/ 3452 w 31235"/>
                  <a:gd name="connsiteY11" fmla="*/ 45877 h 45877"/>
                  <a:gd name="connsiteX12" fmla="*/ 3452 w 31235"/>
                  <a:gd name="connsiteY12" fmla="*/ 45877 h 458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31235" h="45877">
                    <a:moveTo>
                      <a:pt x="3452" y="45877"/>
                    </a:moveTo>
                    <a:cubicBezTo>
                      <a:pt x="2408" y="45872"/>
                      <a:pt x="1421" y="45395"/>
                      <a:pt x="767" y="44581"/>
                    </a:cubicBezTo>
                    <a:cubicBezTo>
                      <a:pt x="113" y="43767"/>
                      <a:pt x="-142" y="42702"/>
                      <a:pt x="76" y="41681"/>
                    </a:cubicBezTo>
                    <a:cubicBezTo>
                      <a:pt x="295" y="40660"/>
                      <a:pt x="960" y="39790"/>
                      <a:pt x="1889" y="39313"/>
                    </a:cubicBezTo>
                    <a:cubicBezTo>
                      <a:pt x="8581" y="36007"/>
                      <a:pt x="14221" y="30903"/>
                      <a:pt x="18178" y="24573"/>
                    </a:cubicBezTo>
                    <a:cubicBezTo>
                      <a:pt x="22134" y="18242"/>
                      <a:pt x="24251" y="10936"/>
                      <a:pt x="24290" y="3472"/>
                    </a:cubicBezTo>
                    <a:cubicBezTo>
                      <a:pt x="24290" y="2232"/>
                      <a:pt x="24953" y="1086"/>
                      <a:pt x="26026" y="465"/>
                    </a:cubicBezTo>
                    <a:cubicBezTo>
                      <a:pt x="27100" y="-155"/>
                      <a:pt x="28426" y="-155"/>
                      <a:pt x="29499" y="465"/>
                    </a:cubicBezTo>
                    <a:cubicBezTo>
                      <a:pt x="30573" y="1086"/>
                      <a:pt x="31236" y="2232"/>
                      <a:pt x="31236" y="3472"/>
                    </a:cubicBezTo>
                    <a:cubicBezTo>
                      <a:pt x="31200" y="12221"/>
                      <a:pt x="28728" y="20787"/>
                      <a:pt x="24097" y="28210"/>
                    </a:cubicBezTo>
                    <a:cubicBezTo>
                      <a:pt x="19465" y="35632"/>
                      <a:pt x="12858" y="41618"/>
                      <a:pt x="5015" y="45495"/>
                    </a:cubicBezTo>
                    <a:cubicBezTo>
                      <a:pt x="4536" y="45755"/>
                      <a:pt x="3998" y="45887"/>
                      <a:pt x="3452" y="45877"/>
                    </a:cubicBezTo>
                    <a:lnTo>
                      <a:pt x="3452" y="45877"/>
                    </a:lnTo>
                    <a:close/>
                  </a:path>
                </a:pathLst>
              </a:custGeom>
              <a:grpFill/>
              <a:ln w="138" cap="flat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F4B20C80-D9C3-6370-DF3B-3C21CB2FAA59}"/>
              </a:ext>
            </a:extLst>
          </p:cNvPr>
          <p:cNvGrpSpPr/>
          <p:nvPr/>
        </p:nvGrpSpPr>
        <p:grpSpPr>
          <a:xfrm>
            <a:off x="2050451" y="2301853"/>
            <a:ext cx="122103" cy="204870"/>
            <a:chOff x="248530" y="2050744"/>
            <a:chExt cx="122103" cy="204870"/>
          </a:xfrm>
        </p:grpSpPr>
        <p:sp>
          <p:nvSpPr>
            <p:cNvPr id="20" name="Arrow: Pentagon 19">
              <a:extLst>
                <a:ext uri="{FF2B5EF4-FFF2-40B4-BE49-F238E27FC236}">
                  <a16:creationId xmlns:a16="http://schemas.microsoft.com/office/drawing/2014/main" id="{81C7EA0D-C2B8-7D79-C7DF-22336C0764DA}"/>
                </a:ext>
              </a:extLst>
            </p:cNvPr>
            <p:cNvSpPr/>
            <p:nvPr/>
          </p:nvSpPr>
          <p:spPr>
            <a:xfrm rot="16200000">
              <a:off x="223427" y="2108408"/>
              <a:ext cx="172358" cy="122054"/>
            </a:xfrm>
            <a:prstGeom prst="homePlate">
              <a:avLst/>
            </a:prstGeom>
            <a:gradFill>
              <a:gsLst>
                <a:gs pos="0">
                  <a:srgbClr val="F0EDF3">
                    <a:alpha val="0"/>
                  </a:srgbClr>
                </a:gs>
                <a:gs pos="100000">
                  <a:schemeClr val="accent2"/>
                </a:gs>
              </a:gsLst>
              <a:lin ang="21594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1" name="Graphic 20">
              <a:extLst>
                <a:ext uri="{FF2B5EF4-FFF2-40B4-BE49-F238E27FC236}">
                  <a16:creationId xmlns:a16="http://schemas.microsoft.com/office/drawing/2014/main" id="{D43FA752-CCAB-0985-BE73-26D3BD7CA97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5400000">
              <a:off x="258654" y="2040666"/>
              <a:ext cx="101898" cy="122054"/>
            </a:xfrm>
            <a:prstGeom prst="rect">
              <a:avLst/>
            </a:prstGeom>
          </p:spPr>
        </p:pic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580E1066-41A9-8918-EA3B-03D3230C1E6C}"/>
              </a:ext>
            </a:extLst>
          </p:cNvPr>
          <p:cNvGrpSpPr/>
          <p:nvPr/>
        </p:nvGrpSpPr>
        <p:grpSpPr>
          <a:xfrm>
            <a:off x="2050347" y="2489998"/>
            <a:ext cx="122103" cy="204870"/>
            <a:chOff x="248530" y="2050744"/>
            <a:chExt cx="122103" cy="204870"/>
          </a:xfrm>
        </p:grpSpPr>
        <p:sp>
          <p:nvSpPr>
            <p:cNvPr id="27" name="Arrow: Pentagon 26">
              <a:extLst>
                <a:ext uri="{FF2B5EF4-FFF2-40B4-BE49-F238E27FC236}">
                  <a16:creationId xmlns:a16="http://schemas.microsoft.com/office/drawing/2014/main" id="{CADF6AAC-9E5C-A430-B181-FE5219CB3D22}"/>
                </a:ext>
              </a:extLst>
            </p:cNvPr>
            <p:cNvSpPr/>
            <p:nvPr/>
          </p:nvSpPr>
          <p:spPr>
            <a:xfrm rot="16200000">
              <a:off x="223427" y="2108408"/>
              <a:ext cx="172358" cy="122054"/>
            </a:xfrm>
            <a:prstGeom prst="homePlate">
              <a:avLst/>
            </a:prstGeom>
            <a:gradFill>
              <a:gsLst>
                <a:gs pos="0">
                  <a:srgbClr val="F0EDF3">
                    <a:alpha val="0"/>
                  </a:srgbClr>
                </a:gs>
                <a:gs pos="100000">
                  <a:schemeClr val="accent2"/>
                </a:gs>
              </a:gsLst>
              <a:lin ang="21594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9" name="Graphic 28">
              <a:extLst>
                <a:ext uri="{FF2B5EF4-FFF2-40B4-BE49-F238E27FC236}">
                  <a16:creationId xmlns:a16="http://schemas.microsoft.com/office/drawing/2014/main" id="{11D96A06-A340-5D86-D928-4F3CB831F2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5400000">
              <a:off x="258654" y="2040666"/>
              <a:ext cx="101898" cy="122054"/>
            </a:xfrm>
            <a:prstGeom prst="rect">
              <a:avLst/>
            </a:prstGeom>
          </p:spPr>
        </p:pic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B2347CC6-9D9B-D5AB-CE19-AE08BCFB8769}"/>
              </a:ext>
            </a:extLst>
          </p:cNvPr>
          <p:cNvGrpSpPr/>
          <p:nvPr/>
        </p:nvGrpSpPr>
        <p:grpSpPr>
          <a:xfrm>
            <a:off x="2053228" y="2669405"/>
            <a:ext cx="122103" cy="204870"/>
            <a:chOff x="248530" y="2050744"/>
            <a:chExt cx="122103" cy="204870"/>
          </a:xfrm>
        </p:grpSpPr>
        <p:sp>
          <p:nvSpPr>
            <p:cNvPr id="67" name="Arrow: Pentagon 66">
              <a:extLst>
                <a:ext uri="{FF2B5EF4-FFF2-40B4-BE49-F238E27FC236}">
                  <a16:creationId xmlns:a16="http://schemas.microsoft.com/office/drawing/2014/main" id="{ABC30BDF-C50E-EB41-57F1-EE7927FD867E}"/>
                </a:ext>
              </a:extLst>
            </p:cNvPr>
            <p:cNvSpPr/>
            <p:nvPr/>
          </p:nvSpPr>
          <p:spPr>
            <a:xfrm rot="16200000">
              <a:off x="223427" y="2108408"/>
              <a:ext cx="172358" cy="122054"/>
            </a:xfrm>
            <a:prstGeom prst="homePlate">
              <a:avLst/>
            </a:prstGeom>
            <a:gradFill>
              <a:gsLst>
                <a:gs pos="0">
                  <a:srgbClr val="F0EDF3">
                    <a:alpha val="0"/>
                  </a:srgbClr>
                </a:gs>
                <a:gs pos="100000">
                  <a:schemeClr val="accent2"/>
                </a:gs>
              </a:gsLst>
              <a:lin ang="21594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68" name="Graphic 67">
              <a:extLst>
                <a:ext uri="{FF2B5EF4-FFF2-40B4-BE49-F238E27FC236}">
                  <a16:creationId xmlns:a16="http://schemas.microsoft.com/office/drawing/2014/main" id="{6F8516C6-2155-D98B-E28E-37780E352A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5400000">
              <a:off x="258654" y="2040666"/>
              <a:ext cx="101898" cy="122054"/>
            </a:xfrm>
            <a:prstGeom prst="rect">
              <a:avLst/>
            </a:prstGeom>
          </p:spPr>
        </p:pic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A6BE36B4-0A53-D4C1-15A8-020109B65808}"/>
              </a:ext>
            </a:extLst>
          </p:cNvPr>
          <p:cNvGrpSpPr/>
          <p:nvPr/>
        </p:nvGrpSpPr>
        <p:grpSpPr>
          <a:xfrm flipV="1">
            <a:off x="2056219" y="2782562"/>
            <a:ext cx="122103" cy="204870"/>
            <a:chOff x="248530" y="2050744"/>
            <a:chExt cx="122103" cy="204870"/>
          </a:xfrm>
        </p:grpSpPr>
        <p:sp>
          <p:nvSpPr>
            <p:cNvPr id="74" name="Arrow: Pentagon 73">
              <a:extLst>
                <a:ext uri="{FF2B5EF4-FFF2-40B4-BE49-F238E27FC236}">
                  <a16:creationId xmlns:a16="http://schemas.microsoft.com/office/drawing/2014/main" id="{4273EA50-E2B2-2296-F92B-42057FFD344C}"/>
                </a:ext>
              </a:extLst>
            </p:cNvPr>
            <p:cNvSpPr/>
            <p:nvPr/>
          </p:nvSpPr>
          <p:spPr>
            <a:xfrm rot="16200000">
              <a:off x="223427" y="2108408"/>
              <a:ext cx="172358" cy="122054"/>
            </a:xfrm>
            <a:prstGeom prst="homePlate">
              <a:avLst/>
            </a:prstGeom>
            <a:gradFill>
              <a:gsLst>
                <a:gs pos="0">
                  <a:srgbClr val="F0EDF3">
                    <a:alpha val="0"/>
                  </a:srgbClr>
                </a:gs>
                <a:gs pos="100000">
                  <a:schemeClr val="accent2"/>
                </a:gs>
              </a:gsLst>
              <a:lin ang="21594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6" name="Graphic 75">
              <a:extLst>
                <a:ext uri="{FF2B5EF4-FFF2-40B4-BE49-F238E27FC236}">
                  <a16:creationId xmlns:a16="http://schemas.microsoft.com/office/drawing/2014/main" id="{5D30CACB-3AC0-7C72-964C-B588057F5AD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5400000">
              <a:off x="258654" y="2040666"/>
              <a:ext cx="101898" cy="122054"/>
            </a:xfrm>
            <a:prstGeom prst="rect">
              <a:avLst/>
            </a:prstGeom>
          </p:spPr>
        </p:pic>
      </p:grpSp>
    </p:spTree>
    <p:custDataLst>
      <p:tags r:id="rId1"/>
    </p:custDataLst>
    <p:extLst>
      <p:ext uri="{BB962C8B-B14F-4D97-AF65-F5344CB8AC3E}">
        <p14:creationId xmlns:p14="http://schemas.microsoft.com/office/powerpoint/2010/main" val="69037222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DESIGN_ID_OFFICE THEME" val="FhDaPzD4"/>
  <p:tag name="ARTICULATE_SLIDE_THUMBNAIL_REFRESH" val="1"/>
  <p:tag name="ARTICULATE_SLIDE_COUNT" val="1"/>
  <p:tag name="ARTICULATE_PROJECT_OPEN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theme1.xml><?xml version="1.0" encoding="utf-8"?>
<a:theme xmlns:a="http://schemas.openxmlformats.org/drawingml/2006/main" name="Office Theme">
  <a:themeElements>
    <a:clrScheme name="Custom 71">
      <a:dk1>
        <a:sysClr val="windowText" lastClr="000000"/>
      </a:dk1>
      <a:lt1>
        <a:sysClr val="window" lastClr="FFFFFF"/>
      </a:lt1>
      <a:dk2>
        <a:srgbClr val="636363"/>
      </a:dk2>
      <a:lt2>
        <a:srgbClr val="E7E6E6"/>
      </a:lt2>
      <a:accent1>
        <a:srgbClr val="B2A4C3"/>
      </a:accent1>
      <a:accent2>
        <a:srgbClr val="7E679B"/>
      </a:accent2>
      <a:accent3>
        <a:srgbClr val="99B4DF"/>
      </a:accent3>
      <a:accent4>
        <a:srgbClr val="66AFA5"/>
      </a:accent4>
      <a:accent5>
        <a:srgbClr val="BEDFDB"/>
      </a:accent5>
      <a:accent6>
        <a:srgbClr val="636363"/>
      </a:accent6>
      <a:hlink>
        <a:srgbClr val="0563C1"/>
      </a:hlink>
      <a:folHlink>
        <a:srgbClr val="954F72"/>
      </a:folHlink>
    </a:clrScheme>
    <a:fontScheme name="Custom 7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705</TotalTime>
  <Words>170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owerPoint Presentation</vt:lpstr>
    </vt:vector>
  </TitlesOfParts>
  <Company>Nucleus Glob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yn Maskin, PhD (HI)</dc:creator>
  <cp:lastModifiedBy>Ellen Mercado, PhD, CMPP</cp:lastModifiedBy>
  <cp:revision>83</cp:revision>
  <dcterms:created xsi:type="dcterms:W3CDTF">2023-06-02T20:37:04Z</dcterms:created>
  <dcterms:modified xsi:type="dcterms:W3CDTF">2024-04-08T15:36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rticulateGUID">
    <vt:lpwstr>3B8EEB80-ADDA-47E4-A972-F5A9FE01AA88</vt:lpwstr>
  </property>
  <property fmtid="{D5CDD505-2E9C-101B-9397-08002B2CF9AE}" pid="3" name="ArticulatePath">
    <vt:lpwstr>33524039_ActivevsStable_graphical_abstract_v1_08JUN2023_kb</vt:lpwstr>
  </property>
</Properties>
</file>